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  <p:sldMasterId id="2147483660" r:id="rId2"/>
  </p:sldMasterIdLst>
  <p:notesMasterIdLst>
    <p:notesMasterId r:id="rId9"/>
  </p:notesMasterIdLst>
  <p:sldIdLst>
    <p:sldId id="1590" r:id="rId3"/>
    <p:sldId id="256" r:id="rId4"/>
    <p:sldId id="1654" r:id="rId5"/>
    <p:sldId id="1655" r:id="rId6"/>
    <p:sldId id="301" r:id="rId7"/>
    <p:sldId id="1656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Office [2]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79FD3"/>
    <a:srgbClr val="00E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9012ECD-51FC-41F1-AA8D-1B2483CD663E}" styleName="Light Style 2 –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28"/>
    <p:restoredTop sz="96327"/>
  </p:normalViewPr>
  <p:slideViewPr>
    <p:cSldViewPr snapToGrid="0" snapToObjects="1">
      <p:cViewPr varScale="1">
        <p:scale>
          <a:sx n="227" d="100"/>
          <a:sy n="227" d="100"/>
        </p:scale>
        <p:origin x="456" y="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presProps" Target="presProps.xml"/><Relationship Id="rId5" Type="http://schemas.openxmlformats.org/officeDocument/2006/relationships/slide" Target="slides/slide3.xml"/><Relationship Id="rId10" Type="http://schemas.openxmlformats.org/officeDocument/2006/relationships/commentAuthors" Target="commentAuthors.xml"/><Relationship Id="rId4" Type="http://schemas.openxmlformats.org/officeDocument/2006/relationships/slide" Target="slides/slide2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6AFFF9-2B12-B544-8DCE-4A00BD8AB809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9D28C4-4EE5-3C41-9736-354EDB15D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3769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emf"/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6.emf"/><Relationship Id="rId1" Type="http://schemas.openxmlformats.org/officeDocument/2006/relationships/slideMaster" Target="../slideMasters/slideMaster2.xml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6.emf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10.jpg"/></Relationships>
</file>

<file path=ppt/slideLayouts/_rels/slideLayout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6.emf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11.jpg"/></Relationships>
</file>

<file path=ppt/slideLayouts/_rels/slideLayout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6.emf"/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emf"/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emf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1.emf"/></Relationships>
</file>

<file path=ppt/slideLayouts/_rels/slideLayout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emf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1.emf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92E76A-68C5-0744-B0D9-4F9A41D22F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0215D4D-AA68-C145-8F61-D7A1647029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1028A9-31D4-4B4F-9266-DB244EE07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77986-9183-5A40-9AD9-7CDEEE62C713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30144A-9101-6C44-88C7-B12D4DE65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3F42A9-BF9F-E74C-A042-66724A5F9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5A6E2-437F-4140-AC2C-1A3628A0B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933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8B2DC5-8BC1-9246-A3C7-BC47B62318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351F7B-9D82-514E-AD4C-4CB5D8EF49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9B2F3C-1AB9-8F4C-9749-59808A1D2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77986-9183-5A40-9AD9-7CDEEE62C713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100382-B2D8-3A49-95C8-2553C873D1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7FB7B3-B8DF-354C-A5B5-7903DBF06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5A6E2-437F-4140-AC2C-1A3628A0B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1665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02BCF18-E021-674D-A528-20181B913F2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BD2D93-6D5E-7147-B80F-5344F7BF76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C7B6AF-47F5-9346-9EF0-541BCD2D4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77986-9183-5A40-9AD9-7CDEEE62C713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0F3545-88EB-2042-A9F7-DA9AFE07C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015698-8C47-904B-8204-F09A556B66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5A6E2-437F-4140-AC2C-1A3628A0B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7911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_image option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1">
            <a:extLst>
              <a:ext uri="{FF2B5EF4-FFF2-40B4-BE49-F238E27FC236}">
                <a16:creationId xmlns:a16="http://schemas.microsoft.com/office/drawing/2014/main" id="{EE0AABFC-97A8-A742-921E-CC905F0E074E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651" y="441325"/>
            <a:ext cx="2271183" cy="660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2" descr="PPT templates-1-standard-FINAL.jpg">
            <a:extLst>
              <a:ext uri="{FF2B5EF4-FFF2-40B4-BE49-F238E27FC236}">
                <a16:creationId xmlns:a16="http://schemas.microsoft.com/office/drawing/2014/main" id="{62EDE51B-E8CC-F642-88FE-77C204D675E1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055" r="3241"/>
          <a:stretch>
            <a:fillRect/>
          </a:stretch>
        </p:blipFill>
        <p:spPr bwMode="auto">
          <a:xfrm>
            <a:off x="8542867" y="0"/>
            <a:ext cx="3081867" cy="685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 Placeholder 17"/>
          <p:cNvSpPr>
            <a:spLocks noGrp="1"/>
          </p:cNvSpPr>
          <p:nvPr>
            <p:ph type="body" sz="quarter" idx="11"/>
          </p:nvPr>
        </p:nvSpPr>
        <p:spPr>
          <a:xfrm>
            <a:off x="379113" y="2765699"/>
            <a:ext cx="6012163" cy="678126"/>
          </a:xfrm>
          <a:prstGeom prst="rect">
            <a:avLst/>
          </a:prstGeom>
        </p:spPr>
        <p:txBody>
          <a:bodyPr/>
          <a:lstStyle>
            <a:lvl1pPr>
              <a:defRPr sz="210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19" name="Text Placeholder 17"/>
          <p:cNvSpPr>
            <a:spLocks noGrp="1"/>
          </p:cNvSpPr>
          <p:nvPr>
            <p:ph type="body" sz="quarter" idx="12"/>
          </p:nvPr>
        </p:nvSpPr>
        <p:spPr>
          <a:xfrm>
            <a:off x="370486" y="4463088"/>
            <a:ext cx="5649316" cy="409725"/>
          </a:xfrm>
          <a:prstGeom prst="rect">
            <a:avLst/>
          </a:prstGeom>
        </p:spPr>
        <p:txBody>
          <a:bodyPr/>
          <a:lstStyle>
            <a:lvl1pPr>
              <a:defRPr sz="150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23" name="Text Placeholder 22"/>
          <p:cNvSpPr>
            <a:spLocks noGrp="1"/>
          </p:cNvSpPr>
          <p:nvPr>
            <p:ph type="body" sz="quarter" idx="13"/>
          </p:nvPr>
        </p:nvSpPr>
        <p:spPr>
          <a:xfrm>
            <a:off x="378809" y="1959607"/>
            <a:ext cx="6012467" cy="1180231"/>
          </a:xfrm>
          <a:prstGeom prst="rect">
            <a:avLst/>
          </a:prstGeom>
        </p:spPr>
        <p:txBody>
          <a:bodyPr/>
          <a:lstStyle>
            <a:lvl1pPr>
              <a:defRPr sz="3375" b="1" baseline="0">
                <a:solidFill>
                  <a:srgbClr val="006CAB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25" name="Text Placeholder 17"/>
          <p:cNvSpPr>
            <a:spLocks noGrp="1"/>
          </p:cNvSpPr>
          <p:nvPr>
            <p:ph type="body" sz="quarter" idx="14"/>
          </p:nvPr>
        </p:nvSpPr>
        <p:spPr>
          <a:xfrm>
            <a:off x="370183" y="4872813"/>
            <a:ext cx="5649617" cy="409725"/>
          </a:xfrm>
          <a:prstGeom prst="rect">
            <a:avLst/>
          </a:prstGeom>
        </p:spPr>
        <p:txBody>
          <a:bodyPr/>
          <a:lstStyle>
            <a:lvl1pPr>
              <a:defRPr sz="150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1096500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_image option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1">
            <a:extLst>
              <a:ext uri="{FF2B5EF4-FFF2-40B4-BE49-F238E27FC236}">
                <a16:creationId xmlns:a16="http://schemas.microsoft.com/office/drawing/2014/main" id="{483FEADE-38C3-EC4F-ABA3-F6339109D147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651" y="441325"/>
            <a:ext cx="2271183" cy="660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2">
            <a:extLst>
              <a:ext uri="{FF2B5EF4-FFF2-40B4-BE49-F238E27FC236}">
                <a16:creationId xmlns:a16="http://schemas.microsoft.com/office/drawing/2014/main" id="{FBF45440-4540-CA46-8A2F-521F9EE23EE0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4120" b="6369"/>
          <a:stretch>
            <a:fillRect/>
          </a:stretch>
        </p:blipFill>
        <p:spPr bwMode="auto">
          <a:xfrm>
            <a:off x="8610600" y="0"/>
            <a:ext cx="3014133" cy="6865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 Placeholder 17"/>
          <p:cNvSpPr>
            <a:spLocks noGrp="1"/>
          </p:cNvSpPr>
          <p:nvPr>
            <p:ph type="body" sz="quarter" idx="11"/>
          </p:nvPr>
        </p:nvSpPr>
        <p:spPr>
          <a:xfrm>
            <a:off x="379113" y="2765699"/>
            <a:ext cx="6012163" cy="678126"/>
          </a:xfrm>
          <a:prstGeom prst="rect">
            <a:avLst/>
          </a:prstGeom>
        </p:spPr>
        <p:txBody>
          <a:bodyPr/>
          <a:lstStyle>
            <a:lvl1pPr>
              <a:defRPr sz="210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19" name="Text Placeholder 17"/>
          <p:cNvSpPr>
            <a:spLocks noGrp="1"/>
          </p:cNvSpPr>
          <p:nvPr>
            <p:ph type="body" sz="quarter" idx="12"/>
          </p:nvPr>
        </p:nvSpPr>
        <p:spPr>
          <a:xfrm>
            <a:off x="370486" y="4463088"/>
            <a:ext cx="5649316" cy="409725"/>
          </a:xfrm>
          <a:prstGeom prst="rect">
            <a:avLst/>
          </a:prstGeom>
        </p:spPr>
        <p:txBody>
          <a:bodyPr/>
          <a:lstStyle>
            <a:lvl1pPr>
              <a:defRPr sz="150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23" name="Text Placeholder 22"/>
          <p:cNvSpPr>
            <a:spLocks noGrp="1"/>
          </p:cNvSpPr>
          <p:nvPr>
            <p:ph type="body" sz="quarter" idx="13"/>
          </p:nvPr>
        </p:nvSpPr>
        <p:spPr>
          <a:xfrm>
            <a:off x="378809" y="1959607"/>
            <a:ext cx="6012467" cy="1180231"/>
          </a:xfrm>
          <a:prstGeom prst="rect">
            <a:avLst/>
          </a:prstGeom>
        </p:spPr>
        <p:txBody>
          <a:bodyPr/>
          <a:lstStyle>
            <a:lvl1pPr>
              <a:defRPr sz="3375" b="1" baseline="0">
                <a:solidFill>
                  <a:srgbClr val="006CAB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25" name="Text Placeholder 17"/>
          <p:cNvSpPr>
            <a:spLocks noGrp="1"/>
          </p:cNvSpPr>
          <p:nvPr>
            <p:ph type="body" sz="quarter" idx="14"/>
          </p:nvPr>
        </p:nvSpPr>
        <p:spPr>
          <a:xfrm>
            <a:off x="370183" y="4872813"/>
            <a:ext cx="5649617" cy="409725"/>
          </a:xfrm>
          <a:prstGeom prst="rect">
            <a:avLst/>
          </a:prstGeom>
        </p:spPr>
        <p:txBody>
          <a:bodyPr/>
          <a:lstStyle>
            <a:lvl1pPr>
              <a:defRPr sz="150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73683710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_image option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1">
            <a:extLst>
              <a:ext uri="{FF2B5EF4-FFF2-40B4-BE49-F238E27FC236}">
                <a16:creationId xmlns:a16="http://schemas.microsoft.com/office/drawing/2014/main" id="{1131FFC2-D061-E047-97E6-33D01CA45CE3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651" y="441325"/>
            <a:ext cx="2271183" cy="660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2">
            <a:extLst>
              <a:ext uri="{FF2B5EF4-FFF2-40B4-BE49-F238E27FC236}">
                <a16:creationId xmlns:a16="http://schemas.microsoft.com/office/drawing/2014/main" id="{E7B563FC-6339-1545-9DBC-551DB50B2E94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4111" b="6467"/>
          <a:stretch>
            <a:fillRect/>
          </a:stretch>
        </p:blipFill>
        <p:spPr bwMode="auto">
          <a:xfrm>
            <a:off x="8619067" y="0"/>
            <a:ext cx="3014133" cy="685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 Placeholder 17"/>
          <p:cNvSpPr>
            <a:spLocks noGrp="1"/>
          </p:cNvSpPr>
          <p:nvPr>
            <p:ph type="body" sz="quarter" idx="11"/>
          </p:nvPr>
        </p:nvSpPr>
        <p:spPr>
          <a:xfrm>
            <a:off x="379113" y="2765699"/>
            <a:ext cx="6012163" cy="678126"/>
          </a:xfrm>
          <a:prstGeom prst="rect">
            <a:avLst/>
          </a:prstGeom>
        </p:spPr>
        <p:txBody>
          <a:bodyPr/>
          <a:lstStyle>
            <a:lvl1pPr>
              <a:defRPr sz="210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19" name="Text Placeholder 17"/>
          <p:cNvSpPr>
            <a:spLocks noGrp="1"/>
          </p:cNvSpPr>
          <p:nvPr>
            <p:ph type="body" sz="quarter" idx="12"/>
          </p:nvPr>
        </p:nvSpPr>
        <p:spPr>
          <a:xfrm>
            <a:off x="370486" y="4463088"/>
            <a:ext cx="5649316" cy="409725"/>
          </a:xfrm>
          <a:prstGeom prst="rect">
            <a:avLst/>
          </a:prstGeom>
        </p:spPr>
        <p:txBody>
          <a:bodyPr/>
          <a:lstStyle>
            <a:lvl1pPr>
              <a:defRPr sz="150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23" name="Text Placeholder 22"/>
          <p:cNvSpPr>
            <a:spLocks noGrp="1"/>
          </p:cNvSpPr>
          <p:nvPr>
            <p:ph type="body" sz="quarter" idx="13"/>
          </p:nvPr>
        </p:nvSpPr>
        <p:spPr>
          <a:xfrm>
            <a:off x="378809" y="1959607"/>
            <a:ext cx="6012467" cy="1180231"/>
          </a:xfrm>
          <a:prstGeom prst="rect">
            <a:avLst/>
          </a:prstGeom>
        </p:spPr>
        <p:txBody>
          <a:bodyPr/>
          <a:lstStyle>
            <a:lvl1pPr>
              <a:defRPr sz="3375" b="1" baseline="0">
                <a:solidFill>
                  <a:srgbClr val="006CAB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25" name="Text Placeholder 17"/>
          <p:cNvSpPr>
            <a:spLocks noGrp="1"/>
          </p:cNvSpPr>
          <p:nvPr>
            <p:ph type="body" sz="quarter" idx="14"/>
          </p:nvPr>
        </p:nvSpPr>
        <p:spPr>
          <a:xfrm>
            <a:off x="370183" y="4872813"/>
            <a:ext cx="5649617" cy="409725"/>
          </a:xfrm>
          <a:prstGeom prst="rect">
            <a:avLst/>
          </a:prstGeom>
        </p:spPr>
        <p:txBody>
          <a:bodyPr/>
          <a:lstStyle>
            <a:lvl1pPr>
              <a:defRPr sz="150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36981039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_image option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1">
            <a:extLst>
              <a:ext uri="{FF2B5EF4-FFF2-40B4-BE49-F238E27FC236}">
                <a16:creationId xmlns:a16="http://schemas.microsoft.com/office/drawing/2014/main" id="{84AD28F2-6599-1147-ABC4-73B0D2540218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651" y="441325"/>
            <a:ext cx="2271183" cy="660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Freeform 6">
            <a:extLst>
              <a:ext uri="{FF2B5EF4-FFF2-40B4-BE49-F238E27FC236}">
                <a16:creationId xmlns:a16="http://schemas.microsoft.com/office/drawing/2014/main" id="{D99417A8-84CB-3146-BF90-730904981742}"/>
              </a:ext>
            </a:extLst>
          </p:cNvPr>
          <p:cNvSpPr/>
          <p:nvPr userDrawn="1"/>
        </p:nvSpPr>
        <p:spPr>
          <a:xfrm>
            <a:off x="8652399" y="2502"/>
            <a:ext cx="2926807" cy="6882646"/>
          </a:xfrm>
          <a:custGeom>
            <a:avLst/>
            <a:gdLst>
              <a:gd name="connsiteX0" fmla="*/ 0 w 2971800"/>
              <a:gd name="connsiteY0" fmla="*/ 6531 h 6982097"/>
              <a:gd name="connsiteX1" fmla="*/ 0 w 2971800"/>
              <a:gd name="connsiteY1" fmla="*/ 6982097 h 6982097"/>
              <a:gd name="connsiteX2" fmla="*/ 796834 w 2971800"/>
              <a:gd name="connsiteY2" fmla="*/ 6982097 h 6982097"/>
              <a:gd name="connsiteX3" fmla="*/ 796834 w 2971800"/>
              <a:gd name="connsiteY3" fmla="*/ 3997234 h 6982097"/>
              <a:gd name="connsiteX4" fmla="*/ 1051560 w 2971800"/>
              <a:gd name="connsiteY4" fmla="*/ 6969034 h 6982097"/>
              <a:gd name="connsiteX5" fmla="*/ 1939834 w 2971800"/>
              <a:gd name="connsiteY5" fmla="*/ 6969034 h 6982097"/>
              <a:gd name="connsiteX6" fmla="*/ 2168434 w 2971800"/>
              <a:gd name="connsiteY6" fmla="*/ 4023360 h 6982097"/>
              <a:gd name="connsiteX7" fmla="*/ 2168434 w 2971800"/>
              <a:gd name="connsiteY7" fmla="*/ 6949440 h 6982097"/>
              <a:gd name="connsiteX8" fmla="*/ 2971800 w 2971800"/>
              <a:gd name="connsiteY8" fmla="*/ 6916782 h 6982097"/>
              <a:gd name="connsiteX9" fmla="*/ 2971800 w 2971800"/>
              <a:gd name="connsiteY9" fmla="*/ 0 h 6982097"/>
              <a:gd name="connsiteX10" fmla="*/ 1691640 w 2971800"/>
              <a:gd name="connsiteY10" fmla="*/ 0 h 6982097"/>
              <a:gd name="connsiteX11" fmla="*/ 1489166 w 2971800"/>
              <a:gd name="connsiteY11" fmla="*/ 2331720 h 6982097"/>
              <a:gd name="connsiteX12" fmla="*/ 1293223 w 2971800"/>
              <a:gd name="connsiteY12" fmla="*/ 6531 h 6982097"/>
              <a:gd name="connsiteX13" fmla="*/ 0 w 2971800"/>
              <a:gd name="connsiteY13" fmla="*/ 6531 h 6982097"/>
              <a:gd name="connsiteX0" fmla="*/ 0 w 2971800"/>
              <a:gd name="connsiteY0" fmla="*/ 6531 h 6982097"/>
              <a:gd name="connsiteX1" fmla="*/ 0 w 2971800"/>
              <a:gd name="connsiteY1" fmla="*/ 6982097 h 6982097"/>
              <a:gd name="connsiteX2" fmla="*/ 796834 w 2971800"/>
              <a:gd name="connsiteY2" fmla="*/ 6982097 h 6982097"/>
              <a:gd name="connsiteX3" fmla="*/ 796834 w 2971800"/>
              <a:gd name="connsiteY3" fmla="*/ 3997234 h 6982097"/>
              <a:gd name="connsiteX4" fmla="*/ 1051560 w 2971800"/>
              <a:gd name="connsiteY4" fmla="*/ 6969034 h 6982097"/>
              <a:gd name="connsiteX5" fmla="*/ 1939834 w 2971800"/>
              <a:gd name="connsiteY5" fmla="*/ 6969034 h 6982097"/>
              <a:gd name="connsiteX6" fmla="*/ 2168434 w 2971800"/>
              <a:gd name="connsiteY6" fmla="*/ 4023360 h 6982097"/>
              <a:gd name="connsiteX7" fmla="*/ 2168434 w 2971800"/>
              <a:gd name="connsiteY7" fmla="*/ 6949440 h 6982097"/>
              <a:gd name="connsiteX8" fmla="*/ 2961790 w 2971800"/>
              <a:gd name="connsiteY8" fmla="*/ 6976844 h 6982097"/>
              <a:gd name="connsiteX9" fmla="*/ 2971800 w 2971800"/>
              <a:gd name="connsiteY9" fmla="*/ 0 h 6982097"/>
              <a:gd name="connsiteX10" fmla="*/ 1691640 w 2971800"/>
              <a:gd name="connsiteY10" fmla="*/ 0 h 6982097"/>
              <a:gd name="connsiteX11" fmla="*/ 1489166 w 2971800"/>
              <a:gd name="connsiteY11" fmla="*/ 2331720 h 6982097"/>
              <a:gd name="connsiteX12" fmla="*/ 1293223 w 2971800"/>
              <a:gd name="connsiteY12" fmla="*/ 6531 h 6982097"/>
              <a:gd name="connsiteX13" fmla="*/ 0 w 2971800"/>
              <a:gd name="connsiteY13" fmla="*/ 6531 h 6982097"/>
              <a:gd name="connsiteX0" fmla="*/ 0 w 2971800"/>
              <a:gd name="connsiteY0" fmla="*/ 6531 h 6986383"/>
              <a:gd name="connsiteX1" fmla="*/ 0 w 2971800"/>
              <a:gd name="connsiteY1" fmla="*/ 6982097 h 6986383"/>
              <a:gd name="connsiteX2" fmla="*/ 796834 w 2971800"/>
              <a:gd name="connsiteY2" fmla="*/ 6982097 h 6986383"/>
              <a:gd name="connsiteX3" fmla="*/ 796834 w 2971800"/>
              <a:gd name="connsiteY3" fmla="*/ 3997234 h 6986383"/>
              <a:gd name="connsiteX4" fmla="*/ 1051560 w 2971800"/>
              <a:gd name="connsiteY4" fmla="*/ 6969034 h 6986383"/>
              <a:gd name="connsiteX5" fmla="*/ 1939834 w 2971800"/>
              <a:gd name="connsiteY5" fmla="*/ 6969034 h 6986383"/>
              <a:gd name="connsiteX6" fmla="*/ 2168434 w 2971800"/>
              <a:gd name="connsiteY6" fmla="*/ 4023360 h 6986383"/>
              <a:gd name="connsiteX7" fmla="*/ 2175823 w 2971800"/>
              <a:gd name="connsiteY7" fmla="*/ 6986383 h 6986383"/>
              <a:gd name="connsiteX8" fmla="*/ 2961790 w 2971800"/>
              <a:gd name="connsiteY8" fmla="*/ 6976844 h 6986383"/>
              <a:gd name="connsiteX9" fmla="*/ 2971800 w 2971800"/>
              <a:gd name="connsiteY9" fmla="*/ 0 h 6986383"/>
              <a:gd name="connsiteX10" fmla="*/ 1691640 w 2971800"/>
              <a:gd name="connsiteY10" fmla="*/ 0 h 6986383"/>
              <a:gd name="connsiteX11" fmla="*/ 1489166 w 2971800"/>
              <a:gd name="connsiteY11" fmla="*/ 2331720 h 6986383"/>
              <a:gd name="connsiteX12" fmla="*/ 1293223 w 2971800"/>
              <a:gd name="connsiteY12" fmla="*/ 6531 h 6986383"/>
              <a:gd name="connsiteX13" fmla="*/ 0 w 2971800"/>
              <a:gd name="connsiteY13" fmla="*/ 6531 h 6986383"/>
              <a:gd name="connsiteX0" fmla="*/ 0 w 2971800"/>
              <a:gd name="connsiteY0" fmla="*/ 6531 h 6999737"/>
              <a:gd name="connsiteX1" fmla="*/ 0 w 2971800"/>
              <a:gd name="connsiteY1" fmla="*/ 6982097 h 6999737"/>
              <a:gd name="connsiteX2" fmla="*/ 796834 w 2971800"/>
              <a:gd name="connsiteY2" fmla="*/ 6982097 h 6999737"/>
              <a:gd name="connsiteX3" fmla="*/ 796834 w 2971800"/>
              <a:gd name="connsiteY3" fmla="*/ 3997234 h 6999737"/>
              <a:gd name="connsiteX4" fmla="*/ 1051560 w 2971800"/>
              <a:gd name="connsiteY4" fmla="*/ 6969034 h 6999737"/>
              <a:gd name="connsiteX5" fmla="*/ 1939834 w 2971800"/>
              <a:gd name="connsiteY5" fmla="*/ 6969034 h 6999737"/>
              <a:gd name="connsiteX6" fmla="*/ 2168434 w 2971800"/>
              <a:gd name="connsiteY6" fmla="*/ 4023360 h 6999737"/>
              <a:gd name="connsiteX7" fmla="*/ 2175823 w 2971800"/>
              <a:gd name="connsiteY7" fmla="*/ 6986383 h 6999737"/>
              <a:gd name="connsiteX8" fmla="*/ 2961790 w 2971800"/>
              <a:gd name="connsiteY8" fmla="*/ 6999737 h 6999737"/>
              <a:gd name="connsiteX9" fmla="*/ 2971800 w 2971800"/>
              <a:gd name="connsiteY9" fmla="*/ 0 h 6999737"/>
              <a:gd name="connsiteX10" fmla="*/ 1691640 w 2971800"/>
              <a:gd name="connsiteY10" fmla="*/ 0 h 6999737"/>
              <a:gd name="connsiteX11" fmla="*/ 1489166 w 2971800"/>
              <a:gd name="connsiteY11" fmla="*/ 2331720 h 6999737"/>
              <a:gd name="connsiteX12" fmla="*/ 1293223 w 2971800"/>
              <a:gd name="connsiteY12" fmla="*/ 6531 h 6999737"/>
              <a:gd name="connsiteX13" fmla="*/ 0 w 2971800"/>
              <a:gd name="connsiteY13" fmla="*/ 6531 h 6999737"/>
              <a:gd name="connsiteX0" fmla="*/ 0 w 2971800"/>
              <a:gd name="connsiteY0" fmla="*/ 6531 h 6999737"/>
              <a:gd name="connsiteX1" fmla="*/ 0 w 2971800"/>
              <a:gd name="connsiteY1" fmla="*/ 6982097 h 6999737"/>
              <a:gd name="connsiteX2" fmla="*/ 796834 w 2971800"/>
              <a:gd name="connsiteY2" fmla="*/ 6982097 h 6999737"/>
              <a:gd name="connsiteX3" fmla="*/ 796834 w 2971800"/>
              <a:gd name="connsiteY3" fmla="*/ 3997234 h 6999737"/>
              <a:gd name="connsiteX4" fmla="*/ 1051560 w 2971800"/>
              <a:gd name="connsiteY4" fmla="*/ 6969034 h 6999737"/>
              <a:gd name="connsiteX5" fmla="*/ 1939834 w 2971800"/>
              <a:gd name="connsiteY5" fmla="*/ 6969034 h 6999737"/>
              <a:gd name="connsiteX6" fmla="*/ 2168434 w 2971800"/>
              <a:gd name="connsiteY6" fmla="*/ 4023360 h 6999737"/>
              <a:gd name="connsiteX7" fmla="*/ 2175823 w 2971800"/>
              <a:gd name="connsiteY7" fmla="*/ 6986383 h 6999737"/>
              <a:gd name="connsiteX8" fmla="*/ 2961790 w 2971800"/>
              <a:gd name="connsiteY8" fmla="*/ 6999737 h 6999737"/>
              <a:gd name="connsiteX9" fmla="*/ 2971800 w 2971800"/>
              <a:gd name="connsiteY9" fmla="*/ 0 h 6999737"/>
              <a:gd name="connsiteX10" fmla="*/ 1691640 w 2971800"/>
              <a:gd name="connsiteY10" fmla="*/ 0 h 6999737"/>
              <a:gd name="connsiteX11" fmla="*/ 1489166 w 2971800"/>
              <a:gd name="connsiteY11" fmla="*/ 2331720 h 6999737"/>
              <a:gd name="connsiteX12" fmla="*/ 1293223 w 2971800"/>
              <a:gd name="connsiteY12" fmla="*/ 6531 h 6999737"/>
              <a:gd name="connsiteX13" fmla="*/ 0 w 2971800"/>
              <a:gd name="connsiteY13" fmla="*/ 6531 h 6999737"/>
              <a:gd name="connsiteX0" fmla="*/ 0 w 2971800"/>
              <a:gd name="connsiteY0" fmla="*/ 6531 h 7001646"/>
              <a:gd name="connsiteX1" fmla="*/ 0 w 2971800"/>
              <a:gd name="connsiteY1" fmla="*/ 6982097 h 7001646"/>
              <a:gd name="connsiteX2" fmla="*/ 796834 w 2971800"/>
              <a:gd name="connsiteY2" fmla="*/ 6982097 h 7001646"/>
              <a:gd name="connsiteX3" fmla="*/ 796834 w 2971800"/>
              <a:gd name="connsiteY3" fmla="*/ 3997234 h 7001646"/>
              <a:gd name="connsiteX4" fmla="*/ 1051560 w 2971800"/>
              <a:gd name="connsiteY4" fmla="*/ 6969034 h 7001646"/>
              <a:gd name="connsiteX5" fmla="*/ 1939834 w 2971800"/>
              <a:gd name="connsiteY5" fmla="*/ 6969034 h 7001646"/>
              <a:gd name="connsiteX6" fmla="*/ 2168434 w 2971800"/>
              <a:gd name="connsiteY6" fmla="*/ 4023360 h 7001646"/>
              <a:gd name="connsiteX7" fmla="*/ 2175824 w 2971800"/>
              <a:gd name="connsiteY7" fmla="*/ 7001646 h 7001646"/>
              <a:gd name="connsiteX8" fmla="*/ 2961790 w 2971800"/>
              <a:gd name="connsiteY8" fmla="*/ 6999737 h 7001646"/>
              <a:gd name="connsiteX9" fmla="*/ 2971800 w 2971800"/>
              <a:gd name="connsiteY9" fmla="*/ 0 h 7001646"/>
              <a:gd name="connsiteX10" fmla="*/ 1691640 w 2971800"/>
              <a:gd name="connsiteY10" fmla="*/ 0 h 7001646"/>
              <a:gd name="connsiteX11" fmla="*/ 1489166 w 2971800"/>
              <a:gd name="connsiteY11" fmla="*/ 2331720 h 7001646"/>
              <a:gd name="connsiteX12" fmla="*/ 1293223 w 2971800"/>
              <a:gd name="connsiteY12" fmla="*/ 6531 h 7001646"/>
              <a:gd name="connsiteX13" fmla="*/ 0 w 2971800"/>
              <a:gd name="connsiteY13" fmla="*/ 6531 h 7001646"/>
              <a:gd name="connsiteX0" fmla="*/ 0 w 2971800"/>
              <a:gd name="connsiteY0" fmla="*/ 6531 h 7007189"/>
              <a:gd name="connsiteX1" fmla="*/ 0 w 2971800"/>
              <a:gd name="connsiteY1" fmla="*/ 6982097 h 7007189"/>
              <a:gd name="connsiteX2" fmla="*/ 796834 w 2971800"/>
              <a:gd name="connsiteY2" fmla="*/ 6982097 h 7007189"/>
              <a:gd name="connsiteX3" fmla="*/ 796834 w 2971800"/>
              <a:gd name="connsiteY3" fmla="*/ 3997234 h 7007189"/>
              <a:gd name="connsiteX4" fmla="*/ 1051560 w 2971800"/>
              <a:gd name="connsiteY4" fmla="*/ 6969034 h 7007189"/>
              <a:gd name="connsiteX5" fmla="*/ 1939834 w 2971800"/>
              <a:gd name="connsiteY5" fmla="*/ 7007189 h 7007189"/>
              <a:gd name="connsiteX6" fmla="*/ 2168434 w 2971800"/>
              <a:gd name="connsiteY6" fmla="*/ 4023360 h 7007189"/>
              <a:gd name="connsiteX7" fmla="*/ 2175824 w 2971800"/>
              <a:gd name="connsiteY7" fmla="*/ 7001646 h 7007189"/>
              <a:gd name="connsiteX8" fmla="*/ 2961790 w 2971800"/>
              <a:gd name="connsiteY8" fmla="*/ 6999737 h 7007189"/>
              <a:gd name="connsiteX9" fmla="*/ 2971800 w 2971800"/>
              <a:gd name="connsiteY9" fmla="*/ 0 h 7007189"/>
              <a:gd name="connsiteX10" fmla="*/ 1691640 w 2971800"/>
              <a:gd name="connsiteY10" fmla="*/ 0 h 7007189"/>
              <a:gd name="connsiteX11" fmla="*/ 1489166 w 2971800"/>
              <a:gd name="connsiteY11" fmla="*/ 2331720 h 7007189"/>
              <a:gd name="connsiteX12" fmla="*/ 1293223 w 2971800"/>
              <a:gd name="connsiteY12" fmla="*/ 6531 h 7007189"/>
              <a:gd name="connsiteX13" fmla="*/ 0 w 2971800"/>
              <a:gd name="connsiteY13" fmla="*/ 6531 h 7007189"/>
              <a:gd name="connsiteX0" fmla="*/ 0 w 2971800"/>
              <a:gd name="connsiteY0" fmla="*/ 6531 h 7007189"/>
              <a:gd name="connsiteX1" fmla="*/ 0 w 2971800"/>
              <a:gd name="connsiteY1" fmla="*/ 6982097 h 7007189"/>
              <a:gd name="connsiteX2" fmla="*/ 796834 w 2971800"/>
              <a:gd name="connsiteY2" fmla="*/ 6982097 h 7007189"/>
              <a:gd name="connsiteX3" fmla="*/ 796834 w 2971800"/>
              <a:gd name="connsiteY3" fmla="*/ 3997234 h 7007189"/>
              <a:gd name="connsiteX4" fmla="*/ 1059191 w 2971800"/>
              <a:gd name="connsiteY4" fmla="*/ 6991927 h 7007189"/>
              <a:gd name="connsiteX5" fmla="*/ 1939834 w 2971800"/>
              <a:gd name="connsiteY5" fmla="*/ 7007189 h 7007189"/>
              <a:gd name="connsiteX6" fmla="*/ 2168434 w 2971800"/>
              <a:gd name="connsiteY6" fmla="*/ 4023360 h 7007189"/>
              <a:gd name="connsiteX7" fmla="*/ 2175824 w 2971800"/>
              <a:gd name="connsiteY7" fmla="*/ 7001646 h 7007189"/>
              <a:gd name="connsiteX8" fmla="*/ 2961790 w 2971800"/>
              <a:gd name="connsiteY8" fmla="*/ 6999737 h 7007189"/>
              <a:gd name="connsiteX9" fmla="*/ 2971800 w 2971800"/>
              <a:gd name="connsiteY9" fmla="*/ 0 h 7007189"/>
              <a:gd name="connsiteX10" fmla="*/ 1691640 w 2971800"/>
              <a:gd name="connsiteY10" fmla="*/ 0 h 7007189"/>
              <a:gd name="connsiteX11" fmla="*/ 1489166 w 2971800"/>
              <a:gd name="connsiteY11" fmla="*/ 2331720 h 7007189"/>
              <a:gd name="connsiteX12" fmla="*/ 1293223 w 2971800"/>
              <a:gd name="connsiteY12" fmla="*/ 6531 h 7007189"/>
              <a:gd name="connsiteX13" fmla="*/ 0 w 2971800"/>
              <a:gd name="connsiteY13" fmla="*/ 6531 h 7007189"/>
              <a:gd name="connsiteX0" fmla="*/ 0 w 2971800"/>
              <a:gd name="connsiteY0" fmla="*/ 6531 h 7007189"/>
              <a:gd name="connsiteX1" fmla="*/ 0 w 2971800"/>
              <a:gd name="connsiteY1" fmla="*/ 6982097 h 7007189"/>
              <a:gd name="connsiteX2" fmla="*/ 796834 w 2971800"/>
              <a:gd name="connsiteY2" fmla="*/ 7004990 h 7007189"/>
              <a:gd name="connsiteX3" fmla="*/ 796834 w 2971800"/>
              <a:gd name="connsiteY3" fmla="*/ 3997234 h 7007189"/>
              <a:gd name="connsiteX4" fmla="*/ 1059191 w 2971800"/>
              <a:gd name="connsiteY4" fmla="*/ 6991927 h 7007189"/>
              <a:gd name="connsiteX5" fmla="*/ 1939834 w 2971800"/>
              <a:gd name="connsiteY5" fmla="*/ 7007189 h 7007189"/>
              <a:gd name="connsiteX6" fmla="*/ 2168434 w 2971800"/>
              <a:gd name="connsiteY6" fmla="*/ 4023360 h 7007189"/>
              <a:gd name="connsiteX7" fmla="*/ 2175824 w 2971800"/>
              <a:gd name="connsiteY7" fmla="*/ 7001646 h 7007189"/>
              <a:gd name="connsiteX8" fmla="*/ 2961790 w 2971800"/>
              <a:gd name="connsiteY8" fmla="*/ 6999737 h 7007189"/>
              <a:gd name="connsiteX9" fmla="*/ 2971800 w 2971800"/>
              <a:gd name="connsiteY9" fmla="*/ 0 h 7007189"/>
              <a:gd name="connsiteX10" fmla="*/ 1691640 w 2971800"/>
              <a:gd name="connsiteY10" fmla="*/ 0 h 7007189"/>
              <a:gd name="connsiteX11" fmla="*/ 1489166 w 2971800"/>
              <a:gd name="connsiteY11" fmla="*/ 2331720 h 7007189"/>
              <a:gd name="connsiteX12" fmla="*/ 1293223 w 2971800"/>
              <a:gd name="connsiteY12" fmla="*/ 6531 h 7007189"/>
              <a:gd name="connsiteX13" fmla="*/ 0 w 2971800"/>
              <a:gd name="connsiteY13" fmla="*/ 6531 h 7007189"/>
              <a:gd name="connsiteX0" fmla="*/ 0 w 2971800"/>
              <a:gd name="connsiteY0" fmla="*/ 6531 h 7007189"/>
              <a:gd name="connsiteX1" fmla="*/ 7631 w 2971800"/>
              <a:gd name="connsiteY1" fmla="*/ 6989729 h 7007189"/>
              <a:gd name="connsiteX2" fmla="*/ 796834 w 2971800"/>
              <a:gd name="connsiteY2" fmla="*/ 7004990 h 7007189"/>
              <a:gd name="connsiteX3" fmla="*/ 796834 w 2971800"/>
              <a:gd name="connsiteY3" fmla="*/ 3997234 h 7007189"/>
              <a:gd name="connsiteX4" fmla="*/ 1059191 w 2971800"/>
              <a:gd name="connsiteY4" fmla="*/ 6991927 h 7007189"/>
              <a:gd name="connsiteX5" fmla="*/ 1939834 w 2971800"/>
              <a:gd name="connsiteY5" fmla="*/ 7007189 h 7007189"/>
              <a:gd name="connsiteX6" fmla="*/ 2168434 w 2971800"/>
              <a:gd name="connsiteY6" fmla="*/ 4023360 h 7007189"/>
              <a:gd name="connsiteX7" fmla="*/ 2175824 w 2971800"/>
              <a:gd name="connsiteY7" fmla="*/ 7001646 h 7007189"/>
              <a:gd name="connsiteX8" fmla="*/ 2961790 w 2971800"/>
              <a:gd name="connsiteY8" fmla="*/ 6999737 h 7007189"/>
              <a:gd name="connsiteX9" fmla="*/ 2971800 w 2971800"/>
              <a:gd name="connsiteY9" fmla="*/ 0 h 7007189"/>
              <a:gd name="connsiteX10" fmla="*/ 1691640 w 2971800"/>
              <a:gd name="connsiteY10" fmla="*/ 0 h 7007189"/>
              <a:gd name="connsiteX11" fmla="*/ 1489166 w 2971800"/>
              <a:gd name="connsiteY11" fmla="*/ 2331720 h 7007189"/>
              <a:gd name="connsiteX12" fmla="*/ 1293223 w 2971800"/>
              <a:gd name="connsiteY12" fmla="*/ 6531 h 7007189"/>
              <a:gd name="connsiteX13" fmla="*/ 0 w 2971800"/>
              <a:gd name="connsiteY13" fmla="*/ 6531 h 7007189"/>
              <a:gd name="connsiteX0" fmla="*/ 7969 w 2979769"/>
              <a:gd name="connsiteY0" fmla="*/ 6531 h 7007189"/>
              <a:gd name="connsiteX1" fmla="*/ 338 w 2979769"/>
              <a:gd name="connsiteY1" fmla="*/ 6997361 h 7007189"/>
              <a:gd name="connsiteX2" fmla="*/ 804803 w 2979769"/>
              <a:gd name="connsiteY2" fmla="*/ 7004990 h 7007189"/>
              <a:gd name="connsiteX3" fmla="*/ 804803 w 2979769"/>
              <a:gd name="connsiteY3" fmla="*/ 3997234 h 7007189"/>
              <a:gd name="connsiteX4" fmla="*/ 1067160 w 2979769"/>
              <a:gd name="connsiteY4" fmla="*/ 6991927 h 7007189"/>
              <a:gd name="connsiteX5" fmla="*/ 1947803 w 2979769"/>
              <a:gd name="connsiteY5" fmla="*/ 7007189 h 7007189"/>
              <a:gd name="connsiteX6" fmla="*/ 2176403 w 2979769"/>
              <a:gd name="connsiteY6" fmla="*/ 4023360 h 7007189"/>
              <a:gd name="connsiteX7" fmla="*/ 2183793 w 2979769"/>
              <a:gd name="connsiteY7" fmla="*/ 7001646 h 7007189"/>
              <a:gd name="connsiteX8" fmla="*/ 2969759 w 2979769"/>
              <a:gd name="connsiteY8" fmla="*/ 6999737 h 7007189"/>
              <a:gd name="connsiteX9" fmla="*/ 2979769 w 2979769"/>
              <a:gd name="connsiteY9" fmla="*/ 0 h 7007189"/>
              <a:gd name="connsiteX10" fmla="*/ 1699609 w 2979769"/>
              <a:gd name="connsiteY10" fmla="*/ 0 h 7007189"/>
              <a:gd name="connsiteX11" fmla="*/ 1497135 w 2979769"/>
              <a:gd name="connsiteY11" fmla="*/ 2331720 h 7007189"/>
              <a:gd name="connsiteX12" fmla="*/ 1301192 w 2979769"/>
              <a:gd name="connsiteY12" fmla="*/ 6531 h 7007189"/>
              <a:gd name="connsiteX13" fmla="*/ 7969 w 2979769"/>
              <a:gd name="connsiteY13" fmla="*/ 6531 h 7007189"/>
              <a:gd name="connsiteX0" fmla="*/ 7969 w 2979769"/>
              <a:gd name="connsiteY0" fmla="*/ 6531 h 7007189"/>
              <a:gd name="connsiteX1" fmla="*/ 338 w 2979769"/>
              <a:gd name="connsiteY1" fmla="*/ 6997361 h 7007189"/>
              <a:gd name="connsiteX2" fmla="*/ 804803 w 2979769"/>
              <a:gd name="connsiteY2" fmla="*/ 7004990 h 7007189"/>
              <a:gd name="connsiteX3" fmla="*/ 804803 w 2979769"/>
              <a:gd name="connsiteY3" fmla="*/ 3997234 h 7007189"/>
              <a:gd name="connsiteX4" fmla="*/ 1074790 w 2979769"/>
              <a:gd name="connsiteY4" fmla="*/ 6999558 h 7007189"/>
              <a:gd name="connsiteX5" fmla="*/ 1947803 w 2979769"/>
              <a:gd name="connsiteY5" fmla="*/ 7007189 h 7007189"/>
              <a:gd name="connsiteX6" fmla="*/ 2176403 w 2979769"/>
              <a:gd name="connsiteY6" fmla="*/ 4023360 h 7007189"/>
              <a:gd name="connsiteX7" fmla="*/ 2183793 w 2979769"/>
              <a:gd name="connsiteY7" fmla="*/ 7001646 h 7007189"/>
              <a:gd name="connsiteX8" fmla="*/ 2969759 w 2979769"/>
              <a:gd name="connsiteY8" fmla="*/ 6999737 h 7007189"/>
              <a:gd name="connsiteX9" fmla="*/ 2979769 w 2979769"/>
              <a:gd name="connsiteY9" fmla="*/ 0 h 7007189"/>
              <a:gd name="connsiteX10" fmla="*/ 1699609 w 2979769"/>
              <a:gd name="connsiteY10" fmla="*/ 0 h 7007189"/>
              <a:gd name="connsiteX11" fmla="*/ 1497135 w 2979769"/>
              <a:gd name="connsiteY11" fmla="*/ 2331720 h 7007189"/>
              <a:gd name="connsiteX12" fmla="*/ 1301192 w 2979769"/>
              <a:gd name="connsiteY12" fmla="*/ 6531 h 7007189"/>
              <a:gd name="connsiteX13" fmla="*/ 7969 w 2979769"/>
              <a:gd name="connsiteY13" fmla="*/ 6531 h 70071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2979769" h="7007189">
                <a:moveTo>
                  <a:pt x="7969" y="6531"/>
                </a:moveTo>
                <a:cubicBezTo>
                  <a:pt x="10513" y="2334264"/>
                  <a:pt x="-2206" y="4669628"/>
                  <a:pt x="338" y="6997361"/>
                </a:cubicBezTo>
                <a:lnTo>
                  <a:pt x="804803" y="7004990"/>
                </a:lnTo>
                <a:lnTo>
                  <a:pt x="804803" y="3997234"/>
                </a:lnTo>
                <a:lnTo>
                  <a:pt x="1074790" y="6999558"/>
                </a:lnTo>
                <a:lnTo>
                  <a:pt x="1947803" y="7007189"/>
                </a:lnTo>
                <a:lnTo>
                  <a:pt x="2176403" y="4023360"/>
                </a:lnTo>
                <a:cubicBezTo>
                  <a:pt x="2178866" y="5016122"/>
                  <a:pt x="2181330" y="6008884"/>
                  <a:pt x="2183793" y="7001646"/>
                </a:cubicBezTo>
                <a:lnTo>
                  <a:pt x="2969759" y="6999737"/>
                </a:lnTo>
                <a:cubicBezTo>
                  <a:pt x="2973096" y="4674122"/>
                  <a:pt x="2976432" y="2325615"/>
                  <a:pt x="2979769" y="0"/>
                </a:cubicBezTo>
                <a:lnTo>
                  <a:pt x="1699609" y="0"/>
                </a:lnTo>
                <a:lnTo>
                  <a:pt x="1497135" y="2331720"/>
                </a:lnTo>
                <a:lnTo>
                  <a:pt x="1301192" y="6531"/>
                </a:lnTo>
                <a:lnTo>
                  <a:pt x="7969" y="6531"/>
                </a:lnTo>
                <a:close/>
              </a:path>
            </a:pathLst>
          </a:custGeom>
          <a:blipFill>
            <a:blip r:embed="rId3"/>
            <a:srcRect/>
            <a:stretch>
              <a:fillRect l="-2460" t="179" r="-31878" b="-557"/>
            </a:stretch>
          </a:blip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sz="1800"/>
          </a:p>
        </p:txBody>
      </p:sp>
      <p:sp>
        <p:nvSpPr>
          <p:cNvPr id="18" name="Text Placeholder 17"/>
          <p:cNvSpPr>
            <a:spLocks noGrp="1"/>
          </p:cNvSpPr>
          <p:nvPr>
            <p:ph type="body" sz="quarter" idx="11"/>
          </p:nvPr>
        </p:nvSpPr>
        <p:spPr>
          <a:xfrm>
            <a:off x="379113" y="2765699"/>
            <a:ext cx="6012163" cy="678126"/>
          </a:xfrm>
          <a:prstGeom prst="rect">
            <a:avLst/>
          </a:prstGeom>
        </p:spPr>
        <p:txBody>
          <a:bodyPr/>
          <a:lstStyle>
            <a:lvl1pPr>
              <a:defRPr sz="210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19" name="Text Placeholder 17"/>
          <p:cNvSpPr>
            <a:spLocks noGrp="1"/>
          </p:cNvSpPr>
          <p:nvPr>
            <p:ph type="body" sz="quarter" idx="12"/>
          </p:nvPr>
        </p:nvSpPr>
        <p:spPr>
          <a:xfrm>
            <a:off x="370486" y="4463088"/>
            <a:ext cx="5649316" cy="409725"/>
          </a:xfrm>
          <a:prstGeom prst="rect">
            <a:avLst/>
          </a:prstGeom>
        </p:spPr>
        <p:txBody>
          <a:bodyPr/>
          <a:lstStyle>
            <a:lvl1pPr>
              <a:defRPr sz="150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23" name="Text Placeholder 22"/>
          <p:cNvSpPr>
            <a:spLocks noGrp="1"/>
          </p:cNvSpPr>
          <p:nvPr>
            <p:ph type="body" sz="quarter" idx="13"/>
          </p:nvPr>
        </p:nvSpPr>
        <p:spPr>
          <a:xfrm>
            <a:off x="378809" y="1959607"/>
            <a:ext cx="6012467" cy="1180231"/>
          </a:xfrm>
          <a:prstGeom prst="rect">
            <a:avLst/>
          </a:prstGeom>
        </p:spPr>
        <p:txBody>
          <a:bodyPr/>
          <a:lstStyle>
            <a:lvl1pPr>
              <a:defRPr sz="3375" b="1" baseline="0">
                <a:solidFill>
                  <a:srgbClr val="006CAB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25" name="Text Placeholder 17"/>
          <p:cNvSpPr>
            <a:spLocks noGrp="1"/>
          </p:cNvSpPr>
          <p:nvPr>
            <p:ph type="body" sz="quarter" idx="14"/>
          </p:nvPr>
        </p:nvSpPr>
        <p:spPr>
          <a:xfrm>
            <a:off x="370183" y="4872813"/>
            <a:ext cx="5649617" cy="409725"/>
          </a:xfrm>
          <a:prstGeom prst="rect">
            <a:avLst/>
          </a:prstGeom>
        </p:spPr>
        <p:txBody>
          <a:bodyPr/>
          <a:lstStyle>
            <a:lvl1pPr>
              <a:defRPr sz="150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22380682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py with subheadings_gre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reeform 7">
            <a:extLst>
              <a:ext uri="{FF2B5EF4-FFF2-40B4-BE49-F238E27FC236}">
                <a16:creationId xmlns:a16="http://schemas.microsoft.com/office/drawing/2014/main" id="{248CB47B-BB22-4944-84E1-80954887E308}"/>
              </a:ext>
            </a:extLst>
          </p:cNvPr>
          <p:cNvSpPr/>
          <p:nvPr userDrawn="1"/>
        </p:nvSpPr>
        <p:spPr>
          <a:xfrm>
            <a:off x="9254067" y="0"/>
            <a:ext cx="2946400" cy="6853238"/>
          </a:xfrm>
          <a:custGeom>
            <a:avLst/>
            <a:gdLst>
              <a:gd name="connsiteX0" fmla="*/ 0 w 3753395"/>
              <a:gd name="connsiteY0" fmla="*/ 0 h 6853646"/>
              <a:gd name="connsiteX1" fmla="*/ 0 w 3753395"/>
              <a:gd name="connsiteY1" fmla="*/ 69669 h 6853646"/>
              <a:gd name="connsiteX2" fmla="*/ 1463040 w 3753395"/>
              <a:gd name="connsiteY2" fmla="*/ 6853646 h 6853646"/>
              <a:gd name="connsiteX3" fmla="*/ 3744686 w 3753395"/>
              <a:gd name="connsiteY3" fmla="*/ 6844937 h 6853646"/>
              <a:gd name="connsiteX4" fmla="*/ 3753395 w 3753395"/>
              <a:gd name="connsiteY4" fmla="*/ 0 h 6853646"/>
              <a:gd name="connsiteX5" fmla="*/ 0 w 3753395"/>
              <a:gd name="connsiteY5" fmla="*/ 0 h 6853646"/>
              <a:gd name="connsiteX0" fmla="*/ 0 w 3772445"/>
              <a:gd name="connsiteY0" fmla="*/ 0 h 6853646"/>
              <a:gd name="connsiteX1" fmla="*/ 19050 w 3772445"/>
              <a:gd name="connsiteY1" fmla="*/ 69669 h 6853646"/>
              <a:gd name="connsiteX2" fmla="*/ 1482090 w 3772445"/>
              <a:gd name="connsiteY2" fmla="*/ 6853646 h 6853646"/>
              <a:gd name="connsiteX3" fmla="*/ 3763736 w 3772445"/>
              <a:gd name="connsiteY3" fmla="*/ 6844937 h 6853646"/>
              <a:gd name="connsiteX4" fmla="*/ 3772445 w 3772445"/>
              <a:gd name="connsiteY4" fmla="*/ 0 h 6853646"/>
              <a:gd name="connsiteX5" fmla="*/ 0 w 3772445"/>
              <a:gd name="connsiteY5" fmla="*/ 0 h 685364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3772445" h="6853646">
                <a:moveTo>
                  <a:pt x="0" y="0"/>
                </a:moveTo>
                <a:lnTo>
                  <a:pt x="19050" y="69669"/>
                </a:lnTo>
                <a:lnTo>
                  <a:pt x="1482090" y="6853646"/>
                </a:lnTo>
                <a:lnTo>
                  <a:pt x="3763736" y="6844937"/>
                </a:lnTo>
                <a:lnTo>
                  <a:pt x="3772445" y="0"/>
                </a:lnTo>
                <a:lnTo>
                  <a:pt x="0" y="0"/>
                </a:lnTo>
                <a:close/>
              </a:path>
            </a:pathLst>
          </a:custGeom>
          <a:solidFill>
            <a:srgbClr val="D2D2D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pic>
        <p:nvPicPr>
          <p:cNvPr id="9" name="Picture 2">
            <a:extLst>
              <a:ext uri="{FF2B5EF4-FFF2-40B4-BE49-F238E27FC236}">
                <a16:creationId xmlns:a16="http://schemas.microsoft.com/office/drawing/2014/main" id="{481263BD-A92C-264F-BB8F-850EF1CCEBDB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96034" y="6319838"/>
            <a:ext cx="1261533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 Placeholder 17"/>
          <p:cNvSpPr>
            <a:spLocks noGrp="1"/>
          </p:cNvSpPr>
          <p:nvPr>
            <p:ph type="body" sz="quarter" idx="11"/>
          </p:nvPr>
        </p:nvSpPr>
        <p:spPr>
          <a:xfrm>
            <a:off x="306060" y="978761"/>
            <a:ext cx="7451725" cy="46646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39" name="Text Placeholder 22"/>
          <p:cNvSpPr>
            <a:spLocks noGrp="1"/>
          </p:cNvSpPr>
          <p:nvPr>
            <p:ph type="body" sz="quarter" idx="13"/>
          </p:nvPr>
        </p:nvSpPr>
        <p:spPr>
          <a:xfrm>
            <a:off x="306060" y="326309"/>
            <a:ext cx="7452027" cy="736956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15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0" name="Text Placeholder 17"/>
          <p:cNvSpPr>
            <a:spLocks noGrp="1"/>
          </p:cNvSpPr>
          <p:nvPr>
            <p:ph type="body" sz="quarter" idx="14"/>
          </p:nvPr>
        </p:nvSpPr>
        <p:spPr>
          <a:xfrm>
            <a:off x="306060" y="1729725"/>
            <a:ext cx="7451725" cy="40164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1" name="Text Placeholder 17"/>
          <p:cNvSpPr>
            <a:spLocks noGrp="1"/>
          </p:cNvSpPr>
          <p:nvPr>
            <p:ph type="body" sz="quarter" idx="16"/>
          </p:nvPr>
        </p:nvSpPr>
        <p:spPr>
          <a:xfrm>
            <a:off x="300212" y="2097682"/>
            <a:ext cx="7451725" cy="172943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</p:txBody>
      </p:sp>
      <p:sp>
        <p:nvSpPr>
          <p:cNvPr id="42" name="Text Placeholder 17"/>
          <p:cNvSpPr>
            <a:spLocks noGrp="1"/>
          </p:cNvSpPr>
          <p:nvPr>
            <p:ph type="body" sz="quarter" idx="17"/>
          </p:nvPr>
        </p:nvSpPr>
        <p:spPr>
          <a:xfrm>
            <a:off x="300212" y="4111608"/>
            <a:ext cx="7451725" cy="40164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3" name="Text Placeholder 17"/>
          <p:cNvSpPr>
            <a:spLocks noGrp="1"/>
          </p:cNvSpPr>
          <p:nvPr>
            <p:ph type="body" sz="quarter" idx="18"/>
          </p:nvPr>
        </p:nvSpPr>
        <p:spPr>
          <a:xfrm>
            <a:off x="294363" y="4513254"/>
            <a:ext cx="7451725" cy="172943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92047582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py with subheadings_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reeform 7">
            <a:extLst>
              <a:ext uri="{FF2B5EF4-FFF2-40B4-BE49-F238E27FC236}">
                <a16:creationId xmlns:a16="http://schemas.microsoft.com/office/drawing/2014/main" id="{7B8E6F42-BBAC-584E-8574-C57363A1A5E6}"/>
              </a:ext>
            </a:extLst>
          </p:cNvPr>
          <p:cNvSpPr/>
          <p:nvPr userDrawn="1"/>
        </p:nvSpPr>
        <p:spPr>
          <a:xfrm>
            <a:off x="9254067" y="0"/>
            <a:ext cx="2946400" cy="6853238"/>
          </a:xfrm>
          <a:custGeom>
            <a:avLst/>
            <a:gdLst>
              <a:gd name="connsiteX0" fmla="*/ 0 w 3753395"/>
              <a:gd name="connsiteY0" fmla="*/ 0 h 6853646"/>
              <a:gd name="connsiteX1" fmla="*/ 0 w 3753395"/>
              <a:gd name="connsiteY1" fmla="*/ 69669 h 6853646"/>
              <a:gd name="connsiteX2" fmla="*/ 1463040 w 3753395"/>
              <a:gd name="connsiteY2" fmla="*/ 6853646 h 6853646"/>
              <a:gd name="connsiteX3" fmla="*/ 3744686 w 3753395"/>
              <a:gd name="connsiteY3" fmla="*/ 6844937 h 6853646"/>
              <a:gd name="connsiteX4" fmla="*/ 3753395 w 3753395"/>
              <a:gd name="connsiteY4" fmla="*/ 0 h 6853646"/>
              <a:gd name="connsiteX5" fmla="*/ 0 w 3753395"/>
              <a:gd name="connsiteY5" fmla="*/ 0 h 6853646"/>
              <a:gd name="connsiteX0" fmla="*/ 0 w 3772445"/>
              <a:gd name="connsiteY0" fmla="*/ 0 h 6853646"/>
              <a:gd name="connsiteX1" fmla="*/ 19050 w 3772445"/>
              <a:gd name="connsiteY1" fmla="*/ 69669 h 6853646"/>
              <a:gd name="connsiteX2" fmla="*/ 1482090 w 3772445"/>
              <a:gd name="connsiteY2" fmla="*/ 6853646 h 6853646"/>
              <a:gd name="connsiteX3" fmla="*/ 3763736 w 3772445"/>
              <a:gd name="connsiteY3" fmla="*/ 6844937 h 6853646"/>
              <a:gd name="connsiteX4" fmla="*/ 3772445 w 3772445"/>
              <a:gd name="connsiteY4" fmla="*/ 0 h 6853646"/>
              <a:gd name="connsiteX5" fmla="*/ 0 w 3772445"/>
              <a:gd name="connsiteY5" fmla="*/ 0 h 685364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3772445" h="6853646">
                <a:moveTo>
                  <a:pt x="0" y="0"/>
                </a:moveTo>
                <a:lnTo>
                  <a:pt x="19050" y="69669"/>
                </a:lnTo>
                <a:lnTo>
                  <a:pt x="1482090" y="6853646"/>
                </a:lnTo>
                <a:lnTo>
                  <a:pt x="3763736" y="6844937"/>
                </a:lnTo>
                <a:lnTo>
                  <a:pt x="3772445" y="0"/>
                </a:lnTo>
                <a:lnTo>
                  <a:pt x="0" y="0"/>
                </a:lnTo>
                <a:close/>
              </a:path>
            </a:pathLst>
          </a:custGeom>
          <a:solidFill>
            <a:srgbClr val="006DA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pic>
        <p:nvPicPr>
          <p:cNvPr id="9" name="Picture 2">
            <a:extLst>
              <a:ext uri="{FF2B5EF4-FFF2-40B4-BE49-F238E27FC236}">
                <a16:creationId xmlns:a16="http://schemas.microsoft.com/office/drawing/2014/main" id="{7DDDC45F-EF24-0440-8A17-202AE0466666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91801" y="6297614"/>
            <a:ext cx="126576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 Placeholder 17"/>
          <p:cNvSpPr>
            <a:spLocks noGrp="1"/>
          </p:cNvSpPr>
          <p:nvPr>
            <p:ph type="body" sz="quarter" idx="11"/>
          </p:nvPr>
        </p:nvSpPr>
        <p:spPr>
          <a:xfrm>
            <a:off x="306060" y="978761"/>
            <a:ext cx="7451725" cy="46646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39" name="Text Placeholder 22"/>
          <p:cNvSpPr>
            <a:spLocks noGrp="1"/>
          </p:cNvSpPr>
          <p:nvPr>
            <p:ph type="body" sz="quarter" idx="13"/>
          </p:nvPr>
        </p:nvSpPr>
        <p:spPr>
          <a:xfrm>
            <a:off x="306060" y="326309"/>
            <a:ext cx="7452027" cy="736956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15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0" name="Text Placeholder 17"/>
          <p:cNvSpPr>
            <a:spLocks noGrp="1"/>
          </p:cNvSpPr>
          <p:nvPr>
            <p:ph type="body" sz="quarter" idx="14"/>
          </p:nvPr>
        </p:nvSpPr>
        <p:spPr>
          <a:xfrm>
            <a:off x="306060" y="1729725"/>
            <a:ext cx="7451725" cy="40164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1" name="Text Placeholder 17"/>
          <p:cNvSpPr>
            <a:spLocks noGrp="1"/>
          </p:cNvSpPr>
          <p:nvPr>
            <p:ph type="body" sz="quarter" idx="16"/>
          </p:nvPr>
        </p:nvSpPr>
        <p:spPr>
          <a:xfrm>
            <a:off x="300212" y="2097682"/>
            <a:ext cx="7451725" cy="172943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</p:txBody>
      </p:sp>
      <p:sp>
        <p:nvSpPr>
          <p:cNvPr id="42" name="Text Placeholder 17"/>
          <p:cNvSpPr>
            <a:spLocks noGrp="1"/>
          </p:cNvSpPr>
          <p:nvPr>
            <p:ph type="body" sz="quarter" idx="17"/>
          </p:nvPr>
        </p:nvSpPr>
        <p:spPr>
          <a:xfrm>
            <a:off x="300212" y="4111608"/>
            <a:ext cx="7451725" cy="40164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3" name="Text Placeholder 17"/>
          <p:cNvSpPr>
            <a:spLocks noGrp="1"/>
          </p:cNvSpPr>
          <p:nvPr>
            <p:ph type="body" sz="quarter" idx="18"/>
          </p:nvPr>
        </p:nvSpPr>
        <p:spPr>
          <a:xfrm>
            <a:off x="294363" y="4513254"/>
            <a:ext cx="7451725" cy="172943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342972890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ulleted list with tex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1">
            <a:extLst>
              <a:ext uri="{FF2B5EF4-FFF2-40B4-BE49-F238E27FC236}">
                <a16:creationId xmlns:a16="http://schemas.microsoft.com/office/drawing/2014/main" id="{692FA669-0C5D-4F4F-B807-E2325F5C8665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53701" y="6397625"/>
            <a:ext cx="126576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4AAC8BA4-B7EA-9141-89F5-3AEBCD4D49E5}"/>
              </a:ext>
            </a:extLst>
          </p:cNvPr>
          <p:cNvSpPr/>
          <p:nvPr userDrawn="1"/>
        </p:nvSpPr>
        <p:spPr>
          <a:xfrm>
            <a:off x="220134" y="85725"/>
            <a:ext cx="2770717" cy="11620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sp>
        <p:nvSpPr>
          <p:cNvPr id="10" name="Freeform 9">
            <a:extLst>
              <a:ext uri="{FF2B5EF4-FFF2-40B4-BE49-F238E27FC236}">
                <a16:creationId xmlns:a16="http://schemas.microsoft.com/office/drawing/2014/main" id="{51ED99E5-D4BD-644C-9707-B9A8B83DB5A3}"/>
              </a:ext>
            </a:extLst>
          </p:cNvPr>
          <p:cNvSpPr/>
          <p:nvPr userDrawn="1"/>
        </p:nvSpPr>
        <p:spPr>
          <a:xfrm>
            <a:off x="9253538" y="0"/>
            <a:ext cx="2947172" cy="6853646"/>
          </a:xfrm>
          <a:custGeom>
            <a:avLst/>
            <a:gdLst>
              <a:gd name="connsiteX0" fmla="*/ 0 w 3753395"/>
              <a:gd name="connsiteY0" fmla="*/ 0 h 6853646"/>
              <a:gd name="connsiteX1" fmla="*/ 0 w 3753395"/>
              <a:gd name="connsiteY1" fmla="*/ 69669 h 6853646"/>
              <a:gd name="connsiteX2" fmla="*/ 1463040 w 3753395"/>
              <a:gd name="connsiteY2" fmla="*/ 6853646 h 6853646"/>
              <a:gd name="connsiteX3" fmla="*/ 3744686 w 3753395"/>
              <a:gd name="connsiteY3" fmla="*/ 6844937 h 6853646"/>
              <a:gd name="connsiteX4" fmla="*/ 3753395 w 3753395"/>
              <a:gd name="connsiteY4" fmla="*/ 0 h 6853646"/>
              <a:gd name="connsiteX5" fmla="*/ 0 w 3753395"/>
              <a:gd name="connsiteY5" fmla="*/ 0 h 6853646"/>
              <a:gd name="connsiteX0" fmla="*/ 0 w 3772445"/>
              <a:gd name="connsiteY0" fmla="*/ 0 h 6853646"/>
              <a:gd name="connsiteX1" fmla="*/ 19050 w 3772445"/>
              <a:gd name="connsiteY1" fmla="*/ 69669 h 6853646"/>
              <a:gd name="connsiteX2" fmla="*/ 1482090 w 3772445"/>
              <a:gd name="connsiteY2" fmla="*/ 6853646 h 6853646"/>
              <a:gd name="connsiteX3" fmla="*/ 3763736 w 3772445"/>
              <a:gd name="connsiteY3" fmla="*/ 6844937 h 6853646"/>
              <a:gd name="connsiteX4" fmla="*/ 3772445 w 3772445"/>
              <a:gd name="connsiteY4" fmla="*/ 0 h 6853646"/>
              <a:gd name="connsiteX5" fmla="*/ 0 w 3772445"/>
              <a:gd name="connsiteY5" fmla="*/ 0 h 685364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3772445" h="6853646">
                <a:moveTo>
                  <a:pt x="0" y="0"/>
                </a:moveTo>
                <a:lnTo>
                  <a:pt x="19050" y="69669"/>
                </a:lnTo>
                <a:lnTo>
                  <a:pt x="1482090" y="6853646"/>
                </a:lnTo>
                <a:lnTo>
                  <a:pt x="3763736" y="6844937"/>
                </a:lnTo>
                <a:lnTo>
                  <a:pt x="3772445" y="0"/>
                </a:lnTo>
                <a:lnTo>
                  <a:pt x="0" y="0"/>
                </a:lnTo>
                <a:close/>
              </a:path>
            </a:pathLst>
          </a:custGeom>
          <a:blipFill dpi="0" rotWithShape="1">
            <a:blip r:embed="rId3"/>
            <a:srcRect/>
            <a:tile tx="1270000" ty="0" sx="80000" sy="80000" flip="none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pic>
        <p:nvPicPr>
          <p:cNvPr id="11" name="Picture 4">
            <a:extLst>
              <a:ext uri="{FF2B5EF4-FFF2-40B4-BE49-F238E27FC236}">
                <a16:creationId xmlns:a16="http://schemas.microsoft.com/office/drawing/2014/main" id="{8BD08F54-D19C-AE4D-803D-3E1F27ECE007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91801" y="6297614"/>
            <a:ext cx="126576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 Placeholder 17"/>
          <p:cNvSpPr>
            <a:spLocks noGrp="1"/>
          </p:cNvSpPr>
          <p:nvPr>
            <p:ph type="body" sz="quarter" idx="11"/>
          </p:nvPr>
        </p:nvSpPr>
        <p:spPr>
          <a:xfrm>
            <a:off x="306060" y="978761"/>
            <a:ext cx="7451725" cy="46646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39" name="Text Placeholder 22"/>
          <p:cNvSpPr>
            <a:spLocks noGrp="1"/>
          </p:cNvSpPr>
          <p:nvPr>
            <p:ph type="body" sz="quarter" idx="13"/>
          </p:nvPr>
        </p:nvSpPr>
        <p:spPr>
          <a:xfrm>
            <a:off x="306060" y="326309"/>
            <a:ext cx="7452027" cy="736956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15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25" name="Text Placeholder 17"/>
          <p:cNvSpPr>
            <a:spLocks noGrp="1"/>
          </p:cNvSpPr>
          <p:nvPr>
            <p:ph type="body" sz="quarter" idx="14"/>
          </p:nvPr>
        </p:nvSpPr>
        <p:spPr>
          <a:xfrm>
            <a:off x="306060" y="1729725"/>
            <a:ext cx="7451725" cy="401647"/>
          </a:xfrm>
          <a:prstGeom prst="rect">
            <a:avLst/>
          </a:prstGeom>
        </p:spPr>
        <p:txBody>
          <a:bodyPr/>
          <a:lstStyle>
            <a:lvl1pPr>
              <a:defRPr sz="1500" b="1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26" name="Text Placeholder 17"/>
          <p:cNvSpPr>
            <a:spLocks noGrp="1"/>
          </p:cNvSpPr>
          <p:nvPr>
            <p:ph type="body" sz="quarter" idx="16"/>
          </p:nvPr>
        </p:nvSpPr>
        <p:spPr>
          <a:xfrm>
            <a:off x="300212" y="2131371"/>
            <a:ext cx="7451725" cy="1729430"/>
          </a:xfrm>
          <a:prstGeom prst="rect">
            <a:avLst/>
          </a:prstGeom>
        </p:spPr>
        <p:txBody>
          <a:bodyPr/>
          <a:lstStyle>
            <a:lvl1pPr marL="257175" indent="-257175">
              <a:buFont typeface="Arial" panose="020B0604020202020204" pitchFamily="34" charset="0"/>
              <a:buChar char="•"/>
              <a:defRPr sz="1500" b="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</p:txBody>
      </p:sp>
      <p:sp>
        <p:nvSpPr>
          <p:cNvPr id="27" name="Text Placeholder 17"/>
          <p:cNvSpPr>
            <a:spLocks noGrp="1"/>
          </p:cNvSpPr>
          <p:nvPr>
            <p:ph type="body" sz="quarter" idx="17"/>
          </p:nvPr>
        </p:nvSpPr>
        <p:spPr>
          <a:xfrm>
            <a:off x="300212" y="4111608"/>
            <a:ext cx="7451725" cy="401647"/>
          </a:xfrm>
          <a:prstGeom prst="rect">
            <a:avLst/>
          </a:prstGeom>
        </p:spPr>
        <p:txBody>
          <a:bodyPr/>
          <a:lstStyle>
            <a:lvl1pPr>
              <a:defRPr sz="1500" b="1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28" name="Text Placeholder 17"/>
          <p:cNvSpPr>
            <a:spLocks noGrp="1"/>
          </p:cNvSpPr>
          <p:nvPr>
            <p:ph type="body" sz="quarter" idx="18"/>
          </p:nvPr>
        </p:nvSpPr>
        <p:spPr>
          <a:xfrm>
            <a:off x="294363" y="4513254"/>
            <a:ext cx="7451725" cy="1729430"/>
          </a:xfrm>
          <a:prstGeom prst="rect">
            <a:avLst/>
          </a:prstGeom>
        </p:spPr>
        <p:txBody>
          <a:bodyPr numCol="2"/>
          <a:lstStyle>
            <a:lvl1pPr marL="257175" marR="0" indent="-257175" algn="l" defTabSz="685800" rtl="0" eaLnBrk="1" fontAlgn="auto" latinLnBrk="0" hangingPunct="1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 sz="1500" b="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89978857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py with two imag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1">
            <a:extLst>
              <a:ext uri="{FF2B5EF4-FFF2-40B4-BE49-F238E27FC236}">
                <a16:creationId xmlns:a16="http://schemas.microsoft.com/office/drawing/2014/main" id="{42E0A6ED-2E7A-EA4E-ADF3-F477E65E468D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53701" y="6397625"/>
            <a:ext cx="126576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2">
            <a:extLst>
              <a:ext uri="{FF2B5EF4-FFF2-40B4-BE49-F238E27FC236}">
                <a16:creationId xmlns:a16="http://schemas.microsoft.com/office/drawing/2014/main" id="{8A1F5781-7A8C-5F4F-9AFB-4797844D9CCE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42034" y="6329363"/>
            <a:ext cx="1261533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 Placeholder 17"/>
          <p:cNvSpPr>
            <a:spLocks noGrp="1"/>
          </p:cNvSpPr>
          <p:nvPr>
            <p:ph type="body" sz="quarter" idx="11"/>
          </p:nvPr>
        </p:nvSpPr>
        <p:spPr>
          <a:xfrm>
            <a:off x="306060" y="1046138"/>
            <a:ext cx="7451725" cy="466468"/>
          </a:xfrm>
          <a:prstGeom prst="rect">
            <a:avLst/>
          </a:prstGeom>
        </p:spPr>
        <p:txBody>
          <a:bodyPr/>
          <a:lstStyle>
            <a:lvl1pPr>
              <a:defRPr sz="180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19" name="Text Placeholder 22"/>
          <p:cNvSpPr>
            <a:spLocks noGrp="1"/>
          </p:cNvSpPr>
          <p:nvPr>
            <p:ph type="body" sz="quarter" idx="13"/>
          </p:nvPr>
        </p:nvSpPr>
        <p:spPr>
          <a:xfrm>
            <a:off x="306060" y="359998"/>
            <a:ext cx="7452027" cy="736956"/>
          </a:xfrm>
          <a:prstGeom prst="rect">
            <a:avLst/>
          </a:prstGeom>
        </p:spPr>
        <p:txBody>
          <a:bodyPr/>
          <a:lstStyle>
            <a:lvl1pPr>
              <a:defRPr sz="3150" b="1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23" name="Text Placeholder 17"/>
          <p:cNvSpPr>
            <a:spLocks noGrp="1"/>
          </p:cNvSpPr>
          <p:nvPr>
            <p:ph type="body" sz="quarter" idx="14"/>
          </p:nvPr>
        </p:nvSpPr>
        <p:spPr>
          <a:xfrm>
            <a:off x="306060" y="1763412"/>
            <a:ext cx="7451725" cy="401647"/>
          </a:xfrm>
          <a:prstGeom prst="rect">
            <a:avLst/>
          </a:prstGeom>
        </p:spPr>
        <p:txBody>
          <a:bodyPr/>
          <a:lstStyle>
            <a:lvl1pPr>
              <a:defRPr sz="1500" b="1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24" name="Text Placeholder 17"/>
          <p:cNvSpPr>
            <a:spLocks noGrp="1"/>
          </p:cNvSpPr>
          <p:nvPr>
            <p:ph type="body" sz="quarter" idx="16"/>
          </p:nvPr>
        </p:nvSpPr>
        <p:spPr>
          <a:xfrm>
            <a:off x="300213" y="2131371"/>
            <a:ext cx="4352700" cy="3976132"/>
          </a:xfrm>
          <a:prstGeom prst="rect">
            <a:avLst/>
          </a:prstGeom>
        </p:spPr>
        <p:txBody>
          <a:bodyPr/>
          <a:lstStyle>
            <a:lvl1pPr>
              <a:defRPr sz="1500" b="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</p:txBody>
      </p:sp>
      <p:sp>
        <p:nvSpPr>
          <p:cNvPr id="25" name="Picture Placeholder 17"/>
          <p:cNvSpPr>
            <a:spLocks noGrp="1"/>
          </p:cNvSpPr>
          <p:nvPr>
            <p:ph type="pic" sz="quarter" idx="17"/>
          </p:nvPr>
        </p:nvSpPr>
        <p:spPr>
          <a:xfrm>
            <a:off x="7380290" y="2520000"/>
            <a:ext cx="4027879" cy="2267900"/>
          </a:xfrm>
          <a:prstGeom prst="rect">
            <a:avLst/>
          </a:prstGeom>
          <a:blipFill dpi="0" rotWithShape="1">
            <a:blip r:embed="rId4"/>
            <a:srcRect/>
            <a:tile tx="0" ty="0" sx="40000" sy="40000" flip="none" algn="ctr"/>
          </a:blipFill>
        </p:spPr>
        <p:txBody>
          <a:bodyPr/>
          <a:lstStyle/>
          <a:p>
            <a:pPr lvl="0"/>
            <a:endParaRPr lang="en-AU" noProof="0" dirty="0"/>
          </a:p>
        </p:txBody>
      </p:sp>
      <p:sp>
        <p:nvSpPr>
          <p:cNvPr id="26" name="Picture Placeholder 19"/>
          <p:cNvSpPr>
            <a:spLocks noGrp="1"/>
          </p:cNvSpPr>
          <p:nvPr>
            <p:ph type="pic" sz="quarter" idx="18"/>
          </p:nvPr>
        </p:nvSpPr>
        <p:spPr>
          <a:xfrm>
            <a:off x="4960508" y="2519365"/>
            <a:ext cx="2281237" cy="2268537"/>
          </a:xfrm>
          <a:prstGeom prst="rect">
            <a:avLst/>
          </a:prstGeom>
          <a:blipFill dpi="0" rotWithShape="1">
            <a:blip r:embed="rId5"/>
            <a:srcRect/>
            <a:tile tx="0" ty="0" sx="40000" sy="40000" flip="none" algn="b"/>
          </a:blipFill>
        </p:spPr>
        <p:txBody>
          <a:bodyPr/>
          <a:lstStyle/>
          <a:p>
            <a:pPr lvl="0"/>
            <a:endParaRPr lang="en-AU" noProof="0"/>
          </a:p>
        </p:txBody>
      </p:sp>
    </p:spTree>
    <p:extLst>
      <p:ext uri="{BB962C8B-B14F-4D97-AF65-F5344CB8AC3E}">
        <p14:creationId xmlns:p14="http://schemas.microsoft.com/office/powerpoint/2010/main" val="4138916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797989-E55E-0D4F-8250-BB31656F93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47082C-F0FD-0641-B80E-741AD9DCC1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75FC6D-CFFB-7D47-BB37-75E344E913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77986-9183-5A40-9AD9-7CDEEE62C713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CEB09C-D454-584D-8EE4-9706F20A8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9D3828-8911-E24B-93F1-A03DF9C91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5A6E2-437F-4140-AC2C-1A3628A0B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82841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Full slide imag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>
            <a:extLst>
              <a:ext uri="{FF2B5EF4-FFF2-40B4-BE49-F238E27FC236}">
                <a16:creationId xmlns:a16="http://schemas.microsoft.com/office/drawing/2014/main" id="{A60E813E-E541-534E-AA29-271B039CF319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53701" y="6397625"/>
            <a:ext cx="126576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>
            <a:extLst>
              <a:ext uri="{FF2B5EF4-FFF2-40B4-BE49-F238E27FC236}">
                <a16:creationId xmlns:a16="http://schemas.microsoft.com/office/drawing/2014/main" id="{0A4272C3-BE9A-6A4C-8073-000200C0B6AD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29900" y="6329363"/>
            <a:ext cx="1261533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Picture Placeholder 4"/>
          <p:cNvSpPr>
            <a:spLocks noGrp="1"/>
          </p:cNvSpPr>
          <p:nvPr>
            <p:ph type="pic" sz="quarter" idx="15"/>
          </p:nvPr>
        </p:nvSpPr>
        <p:spPr>
          <a:xfrm>
            <a:off x="0" y="-8466"/>
            <a:ext cx="10371667" cy="6866466"/>
          </a:xfrm>
          <a:custGeom>
            <a:avLst/>
            <a:gdLst>
              <a:gd name="connsiteX0" fmla="*/ 0 w 12192000"/>
              <a:gd name="connsiteY0" fmla="*/ 0 h 6858000"/>
              <a:gd name="connsiteX1" fmla="*/ 12192000 w 12192000"/>
              <a:gd name="connsiteY1" fmla="*/ 0 h 6858000"/>
              <a:gd name="connsiteX2" fmla="*/ 12192000 w 12192000"/>
              <a:gd name="connsiteY2" fmla="*/ 6858000 h 6858000"/>
              <a:gd name="connsiteX3" fmla="*/ 0 w 12192000"/>
              <a:gd name="connsiteY3" fmla="*/ 6858000 h 6858000"/>
              <a:gd name="connsiteX4" fmla="*/ 0 w 12192000"/>
              <a:gd name="connsiteY4" fmla="*/ 0 h 6858000"/>
              <a:gd name="connsiteX0" fmla="*/ 0 w 12192000"/>
              <a:gd name="connsiteY0" fmla="*/ 0 h 6858000"/>
              <a:gd name="connsiteX1" fmla="*/ 9228667 w 12192000"/>
              <a:gd name="connsiteY1" fmla="*/ 8467 h 6858000"/>
              <a:gd name="connsiteX2" fmla="*/ 12192000 w 12192000"/>
              <a:gd name="connsiteY2" fmla="*/ 6858000 h 6858000"/>
              <a:gd name="connsiteX3" fmla="*/ 0 w 12192000"/>
              <a:gd name="connsiteY3" fmla="*/ 6858000 h 6858000"/>
              <a:gd name="connsiteX4" fmla="*/ 0 w 12192000"/>
              <a:gd name="connsiteY4" fmla="*/ 0 h 6858000"/>
              <a:gd name="connsiteX0" fmla="*/ 0 w 10498666"/>
              <a:gd name="connsiteY0" fmla="*/ 0 h 6858000"/>
              <a:gd name="connsiteX1" fmla="*/ 9228667 w 10498666"/>
              <a:gd name="connsiteY1" fmla="*/ 8467 h 6858000"/>
              <a:gd name="connsiteX2" fmla="*/ 10498666 w 10498666"/>
              <a:gd name="connsiteY2" fmla="*/ 6858000 h 6858000"/>
              <a:gd name="connsiteX3" fmla="*/ 0 w 10498666"/>
              <a:gd name="connsiteY3" fmla="*/ 6858000 h 6858000"/>
              <a:gd name="connsiteX4" fmla="*/ 0 w 10498666"/>
              <a:gd name="connsiteY4" fmla="*/ 0 h 6858000"/>
              <a:gd name="connsiteX0" fmla="*/ 0 w 10498666"/>
              <a:gd name="connsiteY0" fmla="*/ 8466 h 6866466"/>
              <a:gd name="connsiteX1" fmla="*/ 9245601 w 10498666"/>
              <a:gd name="connsiteY1" fmla="*/ 0 h 6866466"/>
              <a:gd name="connsiteX2" fmla="*/ 10498666 w 10498666"/>
              <a:gd name="connsiteY2" fmla="*/ 6866466 h 6866466"/>
              <a:gd name="connsiteX3" fmla="*/ 0 w 10498666"/>
              <a:gd name="connsiteY3" fmla="*/ 6866466 h 6866466"/>
              <a:gd name="connsiteX4" fmla="*/ 0 w 10498666"/>
              <a:gd name="connsiteY4" fmla="*/ 8466 h 6866466"/>
              <a:gd name="connsiteX0" fmla="*/ 0 w 10371666"/>
              <a:gd name="connsiteY0" fmla="*/ 8466 h 6866466"/>
              <a:gd name="connsiteX1" fmla="*/ 9245601 w 10371666"/>
              <a:gd name="connsiteY1" fmla="*/ 0 h 6866466"/>
              <a:gd name="connsiteX2" fmla="*/ 10371666 w 10371666"/>
              <a:gd name="connsiteY2" fmla="*/ 6849533 h 6866466"/>
              <a:gd name="connsiteX3" fmla="*/ 0 w 10371666"/>
              <a:gd name="connsiteY3" fmla="*/ 6866466 h 6866466"/>
              <a:gd name="connsiteX4" fmla="*/ 0 w 10371666"/>
              <a:gd name="connsiteY4" fmla="*/ 8466 h 68664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0371666" h="6866466">
                <a:moveTo>
                  <a:pt x="0" y="8466"/>
                </a:moveTo>
                <a:lnTo>
                  <a:pt x="9245601" y="0"/>
                </a:lnTo>
                <a:lnTo>
                  <a:pt x="10371666" y="6849533"/>
                </a:lnTo>
                <a:lnTo>
                  <a:pt x="0" y="6866466"/>
                </a:lnTo>
                <a:lnTo>
                  <a:pt x="0" y="8466"/>
                </a:lnTo>
                <a:close/>
              </a:path>
            </a:pathLst>
          </a:custGeom>
          <a:blipFill dpi="0" rotWithShape="1">
            <a:blip r:embed="rId4"/>
            <a:srcRect/>
            <a:tile tx="0" ty="0" sx="100000" sy="100000" flip="none" algn="b"/>
          </a:blipFill>
        </p:spPr>
        <p:txBody>
          <a:bodyPr/>
          <a:lstStyle/>
          <a:p>
            <a:pPr lvl="0"/>
            <a:endParaRPr lang="en-AU" noProof="0"/>
          </a:p>
        </p:txBody>
      </p:sp>
      <p:sp>
        <p:nvSpPr>
          <p:cNvPr id="13" name="Text Placeholder 17"/>
          <p:cNvSpPr>
            <a:spLocks noGrp="1"/>
          </p:cNvSpPr>
          <p:nvPr>
            <p:ph type="body" sz="quarter" idx="14"/>
          </p:nvPr>
        </p:nvSpPr>
        <p:spPr>
          <a:xfrm>
            <a:off x="9689171" y="332575"/>
            <a:ext cx="2309631" cy="1302845"/>
          </a:xfrm>
          <a:prstGeom prst="rect">
            <a:avLst/>
          </a:prstGeom>
          <a:noFill/>
        </p:spPr>
        <p:txBody>
          <a:bodyPr/>
          <a:lstStyle>
            <a:lvl1pPr>
              <a:defRPr sz="1500" b="1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22307811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divi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3">
            <a:extLst>
              <a:ext uri="{FF2B5EF4-FFF2-40B4-BE49-F238E27FC236}">
                <a16:creationId xmlns:a16="http://schemas.microsoft.com/office/drawing/2014/main" id="{CA9CF594-534C-1C43-B43A-94B5F663707A}"/>
              </a:ext>
            </a:extLst>
          </p:cNvPr>
          <p:cNvSpPr/>
          <p:nvPr userDrawn="1"/>
        </p:nvSpPr>
        <p:spPr>
          <a:xfrm>
            <a:off x="-19050" y="-9525"/>
            <a:ext cx="9421284" cy="6867525"/>
          </a:xfrm>
          <a:custGeom>
            <a:avLst/>
            <a:gdLst>
              <a:gd name="connsiteX0" fmla="*/ 9525 w 8905875"/>
              <a:gd name="connsiteY0" fmla="*/ 0 h 6896100"/>
              <a:gd name="connsiteX1" fmla="*/ 4724400 w 8905875"/>
              <a:gd name="connsiteY1" fmla="*/ 0 h 6896100"/>
              <a:gd name="connsiteX2" fmla="*/ 8905875 w 8905875"/>
              <a:gd name="connsiteY2" fmla="*/ 6896100 h 6896100"/>
              <a:gd name="connsiteX3" fmla="*/ 0 w 8905875"/>
              <a:gd name="connsiteY3" fmla="*/ 6896100 h 6896100"/>
              <a:gd name="connsiteX4" fmla="*/ 9525 w 8905875"/>
              <a:gd name="connsiteY4" fmla="*/ 0 h 68961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905875" h="6896100">
                <a:moveTo>
                  <a:pt x="9525" y="0"/>
                </a:moveTo>
                <a:lnTo>
                  <a:pt x="4724400" y="0"/>
                </a:lnTo>
                <a:lnTo>
                  <a:pt x="8905875" y="6896100"/>
                </a:lnTo>
                <a:lnTo>
                  <a:pt x="0" y="6896100"/>
                </a:lnTo>
                <a:lnTo>
                  <a:pt x="9525" y="0"/>
                </a:lnTo>
                <a:close/>
              </a:path>
            </a:pathLst>
          </a:custGeom>
          <a:solidFill>
            <a:srgbClr val="006DA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pic>
        <p:nvPicPr>
          <p:cNvPr id="5" name="Picture 2">
            <a:extLst>
              <a:ext uri="{FF2B5EF4-FFF2-40B4-BE49-F238E27FC236}">
                <a16:creationId xmlns:a16="http://schemas.microsoft.com/office/drawing/2014/main" id="{11109F86-2F62-1644-87A0-8662C94D646A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53701" y="6397625"/>
            <a:ext cx="126576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3">
            <a:extLst>
              <a:ext uri="{FF2B5EF4-FFF2-40B4-BE49-F238E27FC236}">
                <a16:creationId xmlns:a16="http://schemas.microsoft.com/office/drawing/2014/main" id="{B07D59E1-F57E-1942-9492-CA9D51ECB08A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06101" y="6373813"/>
            <a:ext cx="126576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4">
            <a:extLst>
              <a:ext uri="{FF2B5EF4-FFF2-40B4-BE49-F238E27FC236}">
                <a16:creationId xmlns:a16="http://schemas.microsoft.com/office/drawing/2014/main" id="{617A671F-A794-D043-8F58-CD0B81EAF9EE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63767" y="6319838"/>
            <a:ext cx="1261533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" name="Text Placeholder 22"/>
          <p:cNvSpPr>
            <a:spLocks noGrp="1"/>
          </p:cNvSpPr>
          <p:nvPr>
            <p:ph type="body" sz="quarter" idx="13"/>
          </p:nvPr>
        </p:nvSpPr>
        <p:spPr>
          <a:xfrm>
            <a:off x="138369" y="1741593"/>
            <a:ext cx="5757607" cy="3435594"/>
          </a:xfrm>
          <a:prstGeom prst="rect">
            <a:avLst/>
          </a:prstGeom>
        </p:spPr>
        <p:txBody>
          <a:bodyPr wrap="square"/>
          <a:lstStyle>
            <a:lvl1pPr algn="r">
              <a:defRPr sz="3300" b="1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sz="quarter" idx="14"/>
          </p:nvPr>
        </p:nvSpPr>
        <p:spPr>
          <a:xfrm>
            <a:off x="6091494" y="1733018"/>
            <a:ext cx="5438775" cy="3435350"/>
          </a:xfrm>
          <a:custGeom>
            <a:avLst/>
            <a:gdLst>
              <a:gd name="connsiteX0" fmla="*/ 0 w 5476875"/>
              <a:gd name="connsiteY0" fmla="*/ 0 h 3435350"/>
              <a:gd name="connsiteX1" fmla="*/ 5476875 w 5476875"/>
              <a:gd name="connsiteY1" fmla="*/ 0 h 3435350"/>
              <a:gd name="connsiteX2" fmla="*/ 5476875 w 5476875"/>
              <a:gd name="connsiteY2" fmla="*/ 3435350 h 3435350"/>
              <a:gd name="connsiteX3" fmla="*/ 0 w 5476875"/>
              <a:gd name="connsiteY3" fmla="*/ 3435350 h 3435350"/>
              <a:gd name="connsiteX4" fmla="*/ 0 w 5476875"/>
              <a:gd name="connsiteY4" fmla="*/ 0 h 3435350"/>
              <a:gd name="connsiteX0" fmla="*/ 19050 w 5476875"/>
              <a:gd name="connsiteY0" fmla="*/ 0 h 3435350"/>
              <a:gd name="connsiteX1" fmla="*/ 5476875 w 5476875"/>
              <a:gd name="connsiteY1" fmla="*/ 0 h 3435350"/>
              <a:gd name="connsiteX2" fmla="*/ 5476875 w 5476875"/>
              <a:gd name="connsiteY2" fmla="*/ 3435350 h 3435350"/>
              <a:gd name="connsiteX3" fmla="*/ 0 w 5476875"/>
              <a:gd name="connsiteY3" fmla="*/ 3435350 h 3435350"/>
              <a:gd name="connsiteX4" fmla="*/ 19050 w 5476875"/>
              <a:gd name="connsiteY4" fmla="*/ 0 h 3435350"/>
              <a:gd name="connsiteX0" fmla="*/ 0 w 5457825"/>
              <a:gd name="connsiteY0" fmla="*/ 0 h 3435350"/>
              <a:gd name="connsiteX1" fmla="*/ 5457825 w 5457825"/>
              <a:gd name="connsiteY1" fmla="*/ 0 h 3435350"/>
              <a:gd name="connsiteX2" fmla="*/ 5457825 w 5457825"/>
              <a:gd name="connsiteY2" fmla="*/ 3435350 h 3435350"/>
              <a:gd name="connsiteX3" fmla="*/ 2266950 w 5457825"/>
              <a:gd name="connsiteY3" fmla="*/ 3435350 h 3435350"/>
              <a:gd name="connsiteX4" fmla="*/ 0 w 5457825"/>
              <a:gd name="connsiteY4" fmla="*/ 0 h 3435350"/>
              <a:gd name="connsiteX0" fmla="*/ 0 w 5438775"/>
              <a:gd name="connsiteY0" fmla="*/ 0 h 3435350"/>
              <a:gd name="connsiteX1" fmla="*/ 5438775 w 5438775"/>
              <a:gd name="connsiteY1" fmla="*/ 0 h 3435350"/>
              <a:gd name="connsiteX2" fmla="*/ 5438775 w 5438775"/>
              <a:gd name="connsiteY2" fmla="*/ 3435350 h 3435350"/>
              <a:gd name="connsiteX3" fmla="*/ 2247900 w 5438775"/>
              <a:gd name="connsiteY3" fmla="*/ 3435350 h 3435350"/>
              <a:gd name="connsiteX4" fmla="*/ 0 w 5438775"/>
              <a:gd name="connsiteY4" fmla="*/ 0 h 34353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438775" h="3435350">
                <a:moveTo>
                  <a:pt x="0" y="0"/>
                </a:moveTo>
                <a:lnTo>
                  <a:pt x="5438775" y="0"/>
                </a:lnTo>
                <a:lnTo>
                  <a:pt x="5438775" y="3435350"/>
                </a:lnTo>
                <a:lnTo>
                  <a:pt x="2247900" y="3435350"/>
                </a:lnTo>
                <a:lnTo>
                  <a:pt x="0" y="0"/>
                </a:lnTo>
                <a:close/>
              </a:path>
            </a:pathLst>
          </a:custGeom>
          <a:blipFill dpi="0" rotWithShape="1">
            <a:blip r:embed="rId4"/>
            <a:srcRect/>
            <a:tile tx="0" ty="0" sx="100000" sy="100000" flip="none" algn="l"/>
          </a:blipFill>
        </p:spPr>
        <p:txBody>
          <a:bodyPr/>
          <a:lstStyle/>
          <a:p>
            <a:pPr lvl="0"/>
            <a:endParaRPr lang="en-AU" noProof="0"/>
          </a:p>
        </p:txBody>
      </p:sp>
    </p:spTree>
    <p:extLst>
      <p:ext uri="{BB962C8B-B14F-4D97-AF65-F5344CB8AC3E}">
        <p14:creationId xmlns:p14="http://schemas.microsoft.com/office/powerpoint/2010/main" val="266375583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Full slide copy_gre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1">
            <a:extLst>
              <a:ext uri="{FF2B5EF4-FFF2-40B4-BE49-F238E27FC236}">
                <a16:creationId xmlns:a16="http://schemas.microsoft.com/office/drawing/2014/main" id="{236358D7-FD24-BA43-BE1B-0BB25DE25855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53701" y="6397625"/>
            <a:ext cx="126576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F082187F-37C9-014C-83B0-C19C13654EC4}"/>
              </a:ext>
            </a:extLst>
          </p:cNvPr>
          <p:cNvSpPr/>
          <p:nvPr userDrawn="1"/>
        </p:nvSpPr>
        <p:spPr>
          <a:xfrm>
            <a:off x="220134" y="85725"/>
            <a:ext cx="2770717" cy="11620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pic>
        <p:nvPicPr>
          <p:cNvPr id="8" name="Picture 3">
            <a:extLst>
              <a:ext uri="{FF2B5EF4-FFF2-40B4-BE49-F238E27FC236}">
                <a16:creationId xmlns:a16="http://schemas.microsoft.com/office/drawing/2014/main" id="{C6AB9131-5062-A143-8C4E-0BD48DFB7F0D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06101" y="6373813"/>
            <a:ext cx="126576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3A41948F-17D8-F741-AC92-D3E0573C43DD}"/>
              </a:ext>
            </a:extLst>
          </p:cNvPr>
          <p:cNvSpPr/>
          <p:nvPr userDrawn="1"/>
        </p:nvSpPr>
        <p:spPr>
          <a:xfrm>
            <a:off x="0" y="6005514"/>
            <a:ext cx="12192000" cy="871537"/>
          </a:xfrm>
          <a:prstGeom prst="rect">
            <a:avLst/>
          </a:prstGeom>
          <a:solidFill>
            <a:srgbClr val="D2D2D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pic>
        <p:nvPicPr>
          <p:cNvPr id="10" name="Picture 5">
            <a:extLst>
              <a:ext uri="{FF2B5EF4-FFF2-40B4-BE49-F238E27FC236}">
                <a16:creationId xmlns:a16="http://schemas.microsoft.com/office/drawing/2014/main" id="{21165AD1-0A5B-B343-89AE-24324B400D2E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42034" y="6329363"/>
            <a:ext cx="1261533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 Placeholder 17"/>
          <p:cNvSpPr>
            <a:spLocks noGrp="1"/>
          </p:cNvSpPr>
          <p:nvPr>
            <p:ph type="body" sz="quarter" idx="11"/>
          </p:nvPr>
        </p:nvSpPr>
        <p:spPr>
          <a:xfrm>
            <a:off x="306060" y="978761"/>
            <a:ext cx="7451725" cy="46646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39" name="Text Placeholder 22"/>
          <p:cNvSpPr>
            <a:spLocks noGrp="1"/>
          </p:cNvSpPr>
          <p:nvPr>
            <p:ph type="body" sz="quarter" idx="13"/>
          </p:nvPr>
        </p:nvSpPr>
        <p:spPr>
          <a:xfrm>
            <a:off x="306060" y="326309"/>
            <a:ext cx="7452027" cy="736956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15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0" name="Text Placeholder 17"/>
          <p:cNvSpPr>
            <a:spLocks noGrp="1"/>
          </p:cNvSpPr>
          <p:nvPr>
            <p:ph type="body" sz="quarter" idx="14"/>
          </p:nvPr>
        </p:nvSpPr>
        <p:spPr>
          <a:xfrm>
            <a:off x="306062" y="1729725"/>
            <a:ext cx="10809615" cy="40164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1" name="Text Placeholder 17"/>
          <p:cNvSpPr>
            <a:spLocks noGrp="1"/>
          </p:cNvSpPr>
          <p:nvPr>
            <p:ph type="body" sz="quarter" idx="16"/>
          </p:nvPr>
        </p:nvSpPr>
        <p:spPr>
          <a:xfrm>
            <a:off x="300211" y="2097683"/>
            <a:ext cx="10815464" cy="329916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1008972743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Full slide copy_tex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1">
            <a:extLst>
              <a:ext uri="{FF2B5EF4-FFF2-40B4-BE49-F238E27FC236}">
                <a16:creationId xmlns:a16="http://schemas.microsoft.com/office/drawing/2014/main" id="{349965EA-ADCA-874C-A3A2-9D2A3A97E48F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53701" y="6397625"/>
            <a:ext cx="126576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203B2D44-F757-3B43-B010-A668E18C0B5F}"/>
              </a:ext>
            </a:extLst>
          </p:cNvPr>
          <p:cNvSpPr/>
          <p:nvPr userDrawn="1"/>
        </p:nvSpPr>
        <p:spPr>
          <a:xfrm>
            <a:off x="220134" y="85725"/>
            <a:ext cx="2770717" cy="11620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pic>
        <p:nvPicPr>
          <p:cNvPr id="8" name="Picture 3">
            <a:extLst>
              <a:ext uri="{FF2B5EF4-FFF2-40B4-BE49-F238E27FC236}">
                <a16:creationId xmlns:a16="http://schemas.microsoft.com/office/drawing/2014/main" id="{0AD7C9D1-060C-0247-B2AB-B38FB575AC4A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06101" y="6373813"/>
            <a:ext cx="126576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A91C9E0E-B613-C440-9742-101B8080A0D0}"/>
              </a:ext>
            </a:extLst>
          </p:cNvPr>
          <p:cNvSpPr/>
          <p:nvPr userDrawn="1"/>
        </p:nvSpPr>
        <p:spPr>
          <a:xfrm>
            <a:off x="0" y="6006108"/>
            <a:ext cx="12192000" cy="870942"/>
          </a:xfrm>
          <a:prstGeom prst="rect">
            <a:avLst/>
          </a:prstGeom>
          <a:blipFill dpi="0" rotWithShape="1">
            <a:blip r:embed="rId3"/>
            <a:srcRect/>
            <a:tile tx="0" ty="0" sx="100000" sy="100000" flip="none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pic>
        <p:nvPicPr>
          <p:cNvPr id="10" name="Picture 5">
            <a:extLst>
              <a:ext uri="{FF2B5EF4-FFF2-40B4-BE49-F238E27FC236}">
                <a16:creationId xmlns:a16="http://schemas.microsoft.com/office/drawing/2014/main" id="{B5D392FF-CE7A-CA45-9311-75C260A16BED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91801" y="6297614"/>
            <a:ext cx="126576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 Placeholder 17"/>
          <p:cNvSpPr>
            <a:spLocks noGrp="1"/>
          </p:cNvSpPr>
          <p:nvPr>
            <p:ph type="body" sz="quarter" idx="11"/>
          </p:nvPr>
        </p:nvSpPr>
        <p:spPr>
          <a:xfrm>
            <a:off x="306060" y="978761"/>
            <a:ext cx="7451725" cy="46646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39" name="Text Placeholder 22"/>
          <p:cNvSpPr>
            <a:spLocks noGrp="1"/>
          </p:cNvSpPr>
          <p:nvPr>
            <p:ph type="body" sz="quarter" idx="13"/>
          </p:nvPr>
        </p:nvSpPr>
        <p:spPr>
          <a:xfrm>
            <a:off x="306060" y="326309"/>
            <a:ext cx="7452027" cy="736956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15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0" name="Text Placeholder 17"/>
          <p:cNvSpPr>
            <a:spLocks noGrp="1"/>
          </p:cNvSpPr>
          <p:nvPr>
            <p:ph type="body" sz="quarter" idx="14"/>
          </p:nvPr>
        </p:nvSpPr>
        <p:spPr>
          <a:xfrm>
            <a:off x="306062" y="1729725"/>
            <a:ext cx="10809615" cy="40164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1" name="Text Placeholder 17"/>
          <p:cNvSpPr>
            <a:spLocks noGrp="1"/>
          </p:cNvSpPr>
          <p:nvPr>
            <p:ph type="body" sz="quarter" idx="16"/>
          </p:nvPr>
        </p:nvSpPr>
        <p:spPr>
          <a:xfrm>
            <a:off x="300211" y="2097683"/>
            <a:ext cx="10815464" cy="329916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1297218413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Full slide copy_texture option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1">
            <a:extLst>
              <a:ext uri="{FF2B5EF4-FFF2-40B4-BE49-F238E27FC236}">
                <a16:creationId xmlns:a16="http://schemas.microsoft.com/office/drawing/2014/main" id="{9D6E6DEE-5477-E748-8AA7-76038F95B6DB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53701" y="6397625"/>
            <a:ext cx="126576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41ED296B-3EFA-7F48-AF17-742E01C878AA}"/>
              </a:ext>
            </a:extLst>
          </p:cNvPr>
          <p:cNvSpPr/>
          <p:nvPr userDrawn="1"/>
        </p:nvSpPr>
        <p:spPr>
          <a:xfrm>
            <a:off x="220134" y="85725"/>
            <a:ext cx="2770717" cy="11620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55AED2C-07D4-3A47-B228-D877419FB9FD}"/>
              </a:ext>
            </a:extLst>
          </p:cNvPr>
          <p:cNvSpPr/>
          <p:nvPr userDrawn="1"/>
        </p:nvSpPr>
        <p:spPr>
          <a:xfrm>
            <a:off x="9992784" y="-19050"/>
            <a:ext cx="124883" cy="11906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pic>
        <p:nvPicPr>
          <p:cNvPr id="9" name="Picture 4">
            <a:extLst>
              <a:ext uri="{FF2B5EF4-FFF2-40B4-BE49-F238E27FC236}">
                <a16:creationId xmlns:a16="http://schemas.microsoft.com/office/drawing/2014/main" id="{E61309CB-DE09-F449-9BC5-EFA17AD34994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06101" y="6373813"/>
            <a:ext cx="126576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5">
            <a:extLst>
              <a:ext uri="{FF2B5EF4-FFF2-40B4-BE49-F238E27FC236}">
                <a16:creationId xmlns:a16="http://schemas.microsoft.com/office/drawing/2014/main" id="{3DAABA73-9A6B-C342-92A3-1E2CC3006531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61601" y="6403975"/>
            <a:ext cx="126576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Isosceles Triangle 20">
            <a:extLst>
              <a:ext uri="{FF2B5EF4-FFF2-40B4-BE49-F238E27FC236}">
                <a16:creationId xmlns:a16="http://schemas.microsoft.com/office/drawing/2014/main" id="{6AA2709E-2CF9-F94E-AEF5-2A69CE350A1B}"/>
              </a:ext>
            </a:extLst>
          </p:cNvPr>
          <p:cNvSpPr/>
          <p:nvPr userDrawn="1"/>
        </p:nvSpPr>
        <p:spPr>
          <a:xfrm rot="16200000" flipH="1">
            <a:off x="8957589" y="-680357"/>
            <a:ext cx="2562223" cy="3884848"/>
          </a:xfrm>
          <a:prstGeom prst="triangle">
            <a:avLst>
              <a:gd name="adj" fmla="val 0"/>
            </a:avLst>
          </a:prstGeom>
          <a:blipFill dpi="0" rotWithShape="0">
            <a:blip r:embed="rId3"/>
            <a:srcRect/>
            <a:tile tx="762000" ty="0" sx="100000" sy="100000" flip="none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pic>
        <p:nvPicPr>
          <p:cNvPr id="12" name="Picture 7">
            <a:extLst>
              <a:ext uri="{FF2B5EF4-FFF2-40B4-BE49-F238E27FC236}">
                <a16:creationId xmlns:a16="http://schemas.microsoft.com/office/drawing/2014/main" id="{70B0F94D-234F-D94F-BE41-34A858AF242C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42034" y="6329363"/>
            <a:ext cx="1261533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 Placeholder 17"/>
          <p:cNvSpPr>
            <a:spLocks noGrp="1"/>
          </p:cNvSpPr>
          <p:nvPr>
            <p:ph type="body" sz="quarter" idx="11"/>
          </p:nvPr>
        </p:nvSpPr>
        <p:spPr>
          <a:xfrm>
            <a:off x="306060" y="978761"/>
            <a:ext cx="7451725" cy="46646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39" name="Text Placeholder 22"/>
          <p:cNvSpPr>
            <a:spLocks noGrp="1"/>
          </p:cNvSpPr>
          <p:nvPr>
            <p:ph type="body" sz="quarter" idx="13"/>
          </p:nvPr>
        </p:nvSpPr>
        <p:spPr>
          <a:xfrm>
            <a:off x="306060" y="326309"/>
            <a:ext cx="7452027" cy="736956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15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0" name="Text Placeholder 17"/>
          <p:cNvSpPr>
            <a:spLocks noGrp="1"/>
          </p:cNvSpPr>
          <p:nvPr>
            <p:ph type="body" sz="quarter" idx="14"/>
          </p:nvPr>
        </p:nvSpPr>
        <p:spPr>
          <a:xfrm>
            <a:off x="306062" y="1729725"/>
            <a:ext cx="10809615" cy="40164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1" name="Text Placeholder 17"/>
          <p:cNvSpPr>
            <a:spLocks noGrp="1"/>
          </p:cNvSpPr>
          <p:nvPr>
            <p:ph type="body" sz="quarter" idx="16"/>
          </p:nvPr>
        </p:nvSpPr>
        <p:spPr>
          <a:xfrm>
            <a:off x="300211" y="2097683"/>
            <a:ext cx="10815464" cy="385358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3908018305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Full slide copy_texture option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1">
            <a:extLst>
              <a:ext uri="{FF2B5EF4-FFF2-40B4-BE49-F238E27FC236}">
                <a16:creationId xmlns:a16="http://schemas.microsoft.com/office/drawing/2014/main" id="{ACFF3F81-A015-D943-8304-6DD237C231B4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53701" y="6397625"/>
            <a:ext cx="126576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F65A3531-0F84-C342-9478-573D82DCE8F7}"/>
              </a:ext>
            </a:extLst>
          </p:cNvPr>
          <p:cNvSpPr/>
          <p:nvPr userDrawn="1"/>
        </p:nvSpPr>
        <p:spPr>
          <a:xfrm>
            <a:off x="220134" y="85725"/>
            <a:ext cx="2770717" cy="11620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pic>
        <p:nvPicPr>
          <p:cNvPr id="8" name="Picture 3">
            <a:extLst>
              <a:ext uri="{FF2B5EF4-FFF2-40B4-BE49-F238E27FC236}">
                <a16:creationId xmlns:a16="http://schemas.microsoft.com/office/drawing/2014/main" id="{B9A2C0D8-4CA6-6047-B3CC-FAC21F28FFA4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06101" y="6373813"/>
            <a:ext cx="126576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4">
            <a:extLst>
              <a:ext uri="{FF2B5EF4-FFF2-40B4-BE49-F238E27FC236}">
                <a16:creationId xmlns:a16="http://schemas.microsoft.com/office/drawing/2014/main" id="{0DA0B19E-1644-2342-9FA0-087CEAB258A2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61601" y="6403975"/>
            <a:ext cx="126576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Isosceles Triangle 20">
            <a:extLst>
              <a:ext uri="{FF2B5EF4-FFF2-40B4-BE49-F238E27FC236}">
                <a16:creationId xmlns:a16="http://schemas.microsoft.com/office/drawing/2014/main" id="{5A1B4892-2A92-0A48-A606-21727D2C6784}"/>
              </a:ext>
            </a:extLst>
          </p:cNvPr>
          <p:cNvSpPr/>
          <p:nvPr userDrawn="1"/>
        </p:nvSpPr>
        <p:spPr>
          <a:xfrm rot="16200000" flipV="1">
            <a:off x="558815" y="4317984"/>
            <a:ext cx="2000250" cy="3117884"/>
          </a:xfrm>
          <a:prstGeom prst="triangle">
            <a:avLst>
              <a:gd name="adj" fmla="val 0"/>
            </a:avLst>
          </a:prstGeom>
          <a:blipFill dpi="0" rotWithShape="0">
            <a:blip r:embed="rId3"/>
            <a:srcRect/>
            <a:tile tx="762000" ty="0" sx="50000" sy="50000" flip="none" algn="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sp>
        <p:nvSpPr>
          <p:cNvPr id="11" name="Freeform 10">
            <a:extLst>
              <a:ext uri="{FF2B5EF4-FFF2-40B4-BE49-F238E27FC236}">
                <a16:creationId xmlns:a16="http://schemas.microsoft.com/office/drawing/2014/main" id="{4E9E6351-3BFB-D042-A566-F612896913F8}"/>
              </a:ext>
            </a:extLst>
          </p:cNvPr>
          <p:cNvSpPr/>
          <p:nvPr userDrawn="1"/>
        </p:nvSpPr>
        <p:spPr>
          <a:xfrm flipH="1">
            <a:off x="0" y="4876800"/>
            <a:ext cx="1176867" cy="1962150"/>
          </a:xfrm>
          <a:custGeom>
            <a:avLst/>
            <a:gdLst>
              <a:gd name="connsiteX0" fmla="*/ 0 w 1485900"/>
              <a:gd name="connsiteY0" fmla="*/ 0 h 6877050"/>
              <a:gd name="connsiteX1" fmla="*/ 1485900 w 1485900"/>
              <a:gd name="connsiteY1" fmla="*/ 19050 h 6877050"/>
              <a:gd name="connsiteX2" fmla="*/ 1485900 w 1485900"/>
              <a:gd name="connsiteY2" fmla="*/ 6877050 h 6877050"/>
              <a:gd name="connsiteX3" fmla="*/ 1457325 w 1485900"/>
              <a:gd name="connsiteY3" fmla="*/ 6858000 h 6877050"/>
              <a:gd name="connsiteX4" fmla="*/ 0 w 1485900"/>
              <a:gd name="connsiteY4" fmla="*/ 0 h 6877050"/>
              <a:gd name="connsiteX0" fmla="*/ 0 w 1485900"/>
              <a:gd name="connsiteY0" fmla="*/ 0 h 6877050"/>
              <a:gd name="connsiteX1" fmla="*/ 1485900 w 1485900"/>
              <a:gd name="connsiteY1" fmla="*/ 19050 h 6877050"/>
              <a:gd name="connsiteX2" fmla="*/ 1485900 w 1485900"/>
              <a:gd name="connsiteY2" fmla="*/ 6877050 h 6877050"/>
              <a:gd name="connsiteX3" fmla="*/ 1438275 w 1485900"/>
              <a:gd name="connsiteY3" fmla="*/ 6858000 h 6877050"/>
              <a:gd name="connsiteX4" fmla="*/ 0 w 1485900"/>
              <a:gd name="connsiteY4" fmla="*/ 0 h 6877050"/>
              <a:gd name="connsiteX0" fmla="*/ 0 w 1485900"/>
              <a:gd name="connsiteY0" fmla="*/ 0 h 6886575"/>
              <a:gd name="connsiteX1" fmla="*/ 1485900 w 1485900"/>
              <a:gd name="connsiteY1" fmla="*/ 19050 h 6886575"/>
              <a:gd name="connsiteX2" fmla="*/ 1485900 w 1485900"/>
              <a:gd name="connsiteY2" fmla="*/ 6877050 h 6886575"/>
              <a:gd name="connsiteX3" fmla="*/ 1438275 w 1485900"/>
              <a:gd name="connsiteY3" fmla="*/ 6886575 h 6886575"/>
              <a:gd name="connsiteX4" fmla="*/ 0 w 1485900"/>
              <a:gd name="connsiteY4" fmla="*/ 0 h 6886575"/>
              <a:gd name="connsiteX0" fmla="*/ 0 w 1495425"/>
              <a:gd name="connsiteY0" fmla="*/ 1417188 h 8303763"/>
              <a:gd name="connsiteX1" fmla="*/ 1495425 w 1495425"/>
              <a:gd name="connsiteY1" fmla="*/ 0 h 8303763"/>
              <a:gd name="connsiteX2" fmla="*/ 1485900 w 1495425"/>
              <a:gd name="connsiteY2" fmla="*/ 8294238 h 8303763"/>
              <a:gd name="connsiteX3" fmla="*/ 1438275 w 1495425"/>
              <a:gd name="connsiteY3" fmla="*/ 8303763 h 8303763"/>
              <a:gd name="connsiteX4" fmla="*/ 0 w 1495425"/>
              <a:gd name="connsiteY4" fmla="*/ 1417188 h 8303763"/>
              <a:gd name="connsiteX0" fmla="*/ 0 w 1543050"/>
              <a:gd name="connsiteY0" fmla="*/ 1159402 h 8303763"/>
              <a:gd name="connsiteX1" fmla="*/ 1543050 w 1543050"/>
              <a:gd name="connsiteY1" fmla="*/ 0 h 8303763"/>
              <a:gd name="connsiteX2" fmla="*/ 1533525 w 1543050"/>
              <a:gd name="connsiteY2" fmla="*/ 8294238 h 8303763"/>
              <a:gd name="connsiteX3" fmla="*/ 1485900 w 1543050"/>
              <a:gd name="connsiteY3" fmla="*/ 8303763 h 8303763"/>
              <a:gd name="connsiteX4" fmla="*/ 0 w 1543050"/>
              <a:gd name="connsiteY4" fmla="*/ 1159402 h 8303763"/>
              <a:gd name="connsiteX0" fmla="*/ 0 w 1533525"/>
              <a:gd name="connsiteY0" fmla="*/ 2374680 h 9519041"/>
              <a:gd name="connsiteX1" fmla="*/ 1514475 w 1533525"/>
              <a:gd name="connsiteY1" fmla="*/ 0 h 9519041"/>
              <a:gd name="connsiteX2" fmla="*/ 1533525 w 1533525"/>
              <a:gd name="connsiteY2" fmla="*/ 9509516 h 9519041"/>
              <a:gd name="connsiteX3" fmla="*/ 1485900 w 1533525"/>
              <a:gd name="connsiteY3" fmla="*/ 9519041 h 9519041"/>
              <a:gd name="connsiteX4" fmla="*/ 0 w 1533525"/>
              <a:gd name="connsiteY4" fmla="*/ 2374680 h 9519041"/>
              <a:gd name="connsiteX0" fmla="*/ 0 w 1362075"/>
              <a:gd name="connsiteY0" fmla="*/ 54604 h 9519041"/>
              <a:gd name="connsiteX1" fmla="*/ 1343025 w 1362075"/>
              <a:gd name="connsiteY1" fmla="*/ 0 h 9519041"/>
              <a:gd name="connsiteX2" fmla="*/ 1362075 w 1362075"/>
              <a:gd name="connsiteY2" fmla="*/ 9509516 h 9519041"/>
              <a:gd name="connsiteX3" fmla="*/ 1314450 w 1362075"/>
              <a:gd name="connsiteY3" fmla="*/ 9519041 h 9519041"/>
              <a:gd name="connsiteX4" fmla="*/ 0 w 1362075"/>
              <a:gd name="connsiteY4" fmla="*/ 54604 h 9519041"/>
              <a:gd name="connsiteX0" fmla="*/ 0 w 2209800"/>
              <a:gd name="connsiteY0" fmla="*/ 17777 h 9519041"/>
              <a:gd name="connsiteX1" fmla="*/ 2190750 w 2209800"/>
              <a:gd name="connsiteY1" fmla="*/ 0 h 9519041"/>
              <a:gd name="connsiteX2" fmla="*/ 2209800 w 2209800"/>
              <a:gd name="connsiteY2" fmla="*/ 9509516 h 9519041"/>
              <a:gd name="connsiteX3" fmla="*/ 2162175 w 2209800"/>
              <a:gd name="connsiteY3" fmla="*/ 9519041 h 9519041"/>
              <a:gd name="connsiteX4" fmla="*/ 0 w 2209800"/>
              <a:gd name="connsiteY4" fmla="*/ 17777 h 9519041"/>
              <a:gd name="connsiteX0" fmla="*/ 0 w 2209800"/>
              <a:gd name="connsiteY0" fmla="*/ 17777 h 9519041"/>
              <a:gd name="connsiteX1" fmla="*/ 2190750 w 2209800"/>
              <a:gd name="connsiteY1" fmla="*/ 0 h 9519041"/>
              <a:gd name="connsiteX2" fmla="*/ 2209800 w 2209800"/>
              <a:gd name="connsiteY2" fmla="*/ 9509516 h 9519041"/>
              <a:gd name="connsiteX3" fmla="*/ 2200275 w 2209800"/>
              <a:gd name="connsiteY3" fmla="*/ 9519041 h 9519041"/>
              <a:gd name="connsiteX4" fmla="*/ 0 w 2209800"/>
              <a:gd name="connsiteY4" fmla="*/ 17777 h 9519041"/>
              <a:gd name="connsiteX0" fmla="*/ 0 w 2209800"/>
              <a:gd name="connsiteY0" fmla="*/ 17777 h 9592694"/>
              <a:gd name="connsiteX1" fmla="*/ 2190750 w 2209800"/>
              <a:gd name="connsiteY1" fmla="*/ 0 h 9592694"/>
              <a:gd name="connsiteX2" fmla="*/ 2209800 w 2209800"/>
              <a:gd name="connsiteY2" fmla="*/ 9509516 h 9592694"/>
              <a:gd name="connsiteX3" fmla="*/ 2200275 w 2209800"/>
              <a:gd name="connsiteY3" fmla="*/ 9592694 h 9592694"/>
              <a:gd name="connsiteX4" fmla="*/ 0 w 2209800"/>
              <a:gd name="connsiteY4" fmla="*/ 17777 h 9592694"/>
              <a:gd name="connsiteX0" fmla="*/ 0 w 2279073"/>
              <a:gd name="connsiteY0" fmla="*/ 4906456 h 9592694"/>
              <a:gd name="connsiteX1" fmla="*/ 2260023 w 2279073"/>
              <a:gd name="connsiteY1" fmla="*/ 0 h 9592694"/>
              <a:gd name="connsiteX2" fmla="*/ 2279073 w 2279073"/>
              <a:gd name="connsiteY2" fmla="*/ 9509516 h 9592694"/>
              <a:gd name="connsiteX3" fmla="*/ 2269548 w 2279073"/>
              <a:gd name="connsiteY3" fmla="*/ 9592694 h 9592694"/>
              <a:gd name="connsiteX4" fmla="*/ 0 w 2279073"/>
              <a:gd name="connsiteY4" fmla="*/ 4906456 h 9592694"/>
              <a:gd name="connsiteX0" fmla="*/ 0 w 1711036"/>
              <a:gd name="connsiteY0" fmla="*/ 3742485 h 9592694"/>
              <a:gd name="connsiteX1" fmla="*/ 1691986 w 1711036"/>
              <a:gd name="connsiteY1" fmla="*/ 0 h 9592694"/>
              <a:gd name="connsiteX2" fmla="*/ 1711036 w 1711036"/>
              <a:gd name="connsiteY2" fmla="*/ 9509516 h 9592694"/>
              <a:gd name="connsiteX3" fmla="*/ 1701511 w 1711036"/>
              <a:gd name="connsiteY3" fmla="*/ 9592694 h 9592694"/>
              <a:gd name="connsiteX4" fmla="*/ 0 w 1711036"/>
              <a:gd name="connsiteY4" fmla="*/ 3742485 h 959269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711036" h="9592694">
                <a:moveTo>
                  <a:pt x="0" y="3742485"/>
                </a:moveTo>
                <a:lnTo>
                  <a:pt x="1691986" y="0"/>
                </a:lnTo>
                <a:lnTo>
                  <a:pt x="1711036" y="9509516"/>
                </a:lnTo>
                <a:lnTo>
                  <a:pt x="1701511" y="9592694"/>
                </a:lnTo>
                <a:lnTo>
                  <a:pt x="0" y="3742485"/>
                </a:lnTo>
                <a:close/>
              </a:path>
            </a:pathLst>
          </a:custGeom>
          <a:solidFill>
            <a:srgbClr val="006CAB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 sz="1800"/>
          </a:p>
        </p:txBody>
      </p:sp>
      <p:pic>
        <p:nvPicPr>
          <p:cNvPr id="12" name="Picture 7">
            <a:extLst>
              <a:ext uri="{FF2B5EF4-FFF2-40B4-BE49-F238E27FC236}">
                <a16:creationId xmlns:a16="http://schemas.microsoft.com/office/drawing/2014/main" id="{F15DD2F8-F9F7-7B46-96E9-54BE35D6F500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42034" y="6329363"/>
            <a:ext cx="1261533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 Placeholder 17"/>
          <p:cNvSpPr>
            <a:spLocks noGrp="1"/>
          </p:cNvSpPr>
          <p:nvPr>
            <p:ph type="body" sz="quarter" idx="11"/>
          </p:nvPr>
        </p:nvSpPr>
        <p:spPr>
          <a:xfrm>
            <a:off x="306060" y="978761"/>
            <a:ext cx="7451725" cy="46646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39" name="Text Placeholder 22"/>
          <p:cNvSpPr>
            <a:spLocks noGrp="1"/>
          </p:cNvSpPr>
          <p:nvPr>
            <p:ph type="body" sz="quarter" idx="13"/>
          </p:nvPr>
        </p:nvSpPr>
        <p:spPr>
          <a:xfrm>
            <a:off x="306060" y="326309"/>
            <a:ext cx="7452027" cy="736956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15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0" name="Text Placeholder 17"/>
          <p:cNvSpPr>
            <a:spLocks noGrp="1"/>
          </p:cNvSpPr>
          <p:nvPr>
            <p:ph type="body" sz="quarter" idx="14"/>
          </p:nvPr>
        </p:nvSpPr>
        <p:spPr>
          <a:xfrm>
            <a:off x="306062" y="1729725"/>
            <a:ext cx="10809615" cy="40164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1" baseline="0">
                <a:solidFill>
                  <a:schemeClr val="tx1"/>
                </a:solidFill>
                <a:latin typeface="Arial Narrow" panose="020B060602020203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1" name="Text Placeholder 17"/>
          <p:cNvSpPr>
            <a:spLocks noGrp="1"/>
          </p:cNvSpPr>
          <p:nvPr>
            <p:ph type="body" sz="quarter" idx="16"/>
          </p:nvPr>
        </p:nvSpPr>
        <p:spPr>
          <a:xfrm>
            <a:off x="300211" y="2097683"/>
            <a:ext cx="10815464" cy="385358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500" b="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3725646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2015BF-C552-A64D-B282-37A49294AE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655F83-F0E7-F64F-A769-0B80AC3990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C5EFBE-69CA-BC44-8F6B-6E0A554208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77986-9183-5A40-9AD9-7CDEEE62C713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9F35D7-D2B0-674A-A09E-01A1ED019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DBE346-47CC-134D-BAB2-C69A3673A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5A6E2-437F-4140-AC2C-1A3628A0B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678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F6B3FE-1584-FA4E-9482-E32C5BEF0D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9A7CA0-236A-D740-B19E-CC92C420A8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29262E-D5E0-F54B-8BE5-CEA2C842B7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A8BA06-C100-3042-A848-6C45967BFE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77986-9183-5A40-9AD9-7CDEEE62C713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D2AE2E-65E5-484E-8597-CB3CC78B5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4A4093-8A3A-CE46-B4ED-4DFD8605CD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5A6E2-437F-4140-AC2C-1A3628A0B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498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22A267-D1A7-4D48-BECA-D7067DD8F1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7D444E-D753-9349-B5AE-7314BB758B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07766D-4E6B-DD43-B469-1830F08BC9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84277D-B97F-A44E-96AE-BC0EEA114F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A2DE63-A4DA-2C49-B968-BB3C1E0A1F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E4348F-5F8C-AD4E-9864-C3FD3DA6E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77986-9183-5A40-9AD9-7CDEEE62C713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989F26E-D586-3448-9C2F-593C37C7E6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922A9D-6EE3-F14E-9527-68E967C5D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5A6E2-437F-4140-AC2C-1A3628A0B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564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FC5F62-C61E-F847-A3B8-BD479BCBAF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23F7A18-F18F-B648-B31A-562A455BD8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77986-9183-5A40-9AD9-7CDEEE62C713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A38C6F-7334-774E-B2B4-B6A1530B0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D2FCC03-513C-6643-990D-7B90F8005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5A6E2-437F-4140-AC2C-1A3628A0B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664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A89E53-98D1-2C49-8FB0-D4F946CF5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77986-9183-5A40-9AD9-7CDEEE62C713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4A0F650-E5D3-8D46-A7DD-024CD2E640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8A9649-F2EF-DF46-9E7C-FA348B4CB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5A6E2-437F-4140-AC2C-1A3628A0B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898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F7DE9A-9D1F-034E-8628-C933DC1BFA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7F138C-44EC-5747-83DE-8FF030D094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7EA998-BF44-4B40-94A0-797476475A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6EFF52-B1CC-6246-9994-D2ED329117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77986-9183-5A40-9AD9-7CDEEE62C713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C081E0-C29E-1648-A0B2-A491A2BF9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C64C05-BFB0-F940-9144-EE48E36F32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5A6E2-437F-4140-AC2C-1A3628A0B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506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1C7730-AC3D-8A4C-834F-E6DEB5BD3D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31F8773-53B7-8F48-89FD-D70CCBAE513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4E01EE-4C65-654F-A21F-EA0B7E9B8E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5BF7CB-5A06-874E-B5BC-F784EAF8B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77986-9183-5A40-9AD9-7CDEEE62C713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EB870C-60E9-5040-98B1-6509A9D74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3ACB0C-88D4-0046-AE52-AB518662C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5A6E2-437F-4140-AC2C-1A3628A0B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140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slideLayout" Target="../slideLayouts/slideLayout24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5" Type="http://schemas.openxmlformats.org/officeDocument/2006/relationships/theme" Target="../theme/theme2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slideLayout" Target="../slideLayouts/slideLayout2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6801186-1D81-2742-9F16-D386762453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72D992-7BFC-C147-A847-11BA30FBF4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15BD0C-6579-1646-8D31-8D1EA25A19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A77986-9183-5A40-9AD9-7CDEEE62C713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F21D26-F35C-D749-A514-D1C3F7EFF39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33EAF0-F596-3340-8E8D-64DFC09D2F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D5A6E2-437F-4140-AC2C-1A3628A0B2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951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7211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</p:sldLayoutIdLst>
  <p:hf hdr="0" ftr="0" dt="0"/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2500" b="1" kern="1200">
          <a:solidFill>
            <a:schemeClr val="bg1"/>
          </a:solidFill>
          <a:latin typeface="Arial Narrow" charset="0"/>
          <a:ea typeface="Arial Narrow" charset="0"/>
          <a:cs typeface="Arial Narrow" charset="0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2500" b="1">
          <a:solidFill>
            <a:schemeClr val="bg1"/>
          </a:solidFill>
          <a:latin typeface="Arial Narrow" panose="020B0604020202020204" pitchFamily="34" charset="0"/>
          <a:ea typeface="Arial Narrow" panose="020B0604020202020204" pitchFamily="34" charset="0"/>
          <a:cs typeface="Arial Narrow" panose="020B0604020202020204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2500" b="1">
          <a:solidFill>
            <a:schemeClr val="bg1"/>
          </a:solidFill>
          <a:latin typeface="Arial Narrow" panose="020B0604020202020204" pitchFamily="34" charset="0"/>
          <a:ea typeface="Arial Narrow" panose="020B0604020202020204" pitchFamily="34" charset="0"/>
          <a:cs typeface="Arial Narrow" panose="020B0604020202020204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2500" b="1">
          <a:solidFill>
            <a:schemeClr val="bg1"/>
          </a:solidFill>
          <a:latin typeface="Arial Narrow" panose="020B0604020202020204" pitchFamily="34" charset="0"/>
          <a:ea typeface="Arial Narrow" panose="020B0604020202020204" pitchFamily="34" charset="0"/>
          <a:cs typeface="Arial Narrow" panose="020B0604020202020204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2500" b="1">
          <a:solidFill>
            <a:schemeClr val="bg1"/>
          </a:solidFill>
          <a:latin typeface="Arial Narrow" panose="020B0604020202020204" pitchFamily="34" charset="0"/>
          <a:ea typeface="Arial Narrow" panose="020B0604020202020204" pitchFamily="34" charset="0"/>
          <a:cs typeface="Arial Narrow" panose="020B060402020202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2500" b="1">
          <a:solidFill>
            <a:schemeClr val="bg1"/>
          </a:solidFill>
          <a:latin typeface="Arial Narrow" panose="020B0604020202020204" pitchFamily="34" charset="0"/>
          <a:ea typeface="Arial Narrow" panose="020B0604020202020204" pitchFamily="34" charset="0"/>
          <a:cs typeface="Arial Narrow" panose="020B060402020202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2500" b="1">
          <a:solidFill>
            <a:schemeClr val="bg1"/>
          </a:solidFill>
          <a:latin typeface="Arial Narrow" panose="020B0604020202020204" pitchFamily="34" charset="0"/>
          <a:ea typeface="Arial Narrow" panose="020B0604020202020204" pitchFamily="34" charset="0"/>
          <a:cs typeface="Arial Narrow" panose="020B060402020202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2500" b="1">
          <a:solidFill>
            <a:schemeClr val="bg1"/>
          </a:solidFill>
          <a:latin typeface="Arial Narrow" panose="020B0604020202020204" pitchFamily="34" charset="0"/>
          <a:ea typeface="Arial Narrow" panose="020B0604020202020204" pitchFamily="34" charset="0"/>
          <a:cs typeface="Arial Narrow" panose="020B060402020202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2500" b="1">
          <a:solidFill>
            <a:schemeClr val="bg1"/>
          </a:solidFill>
          <a:latin typeface="Arial Narrow" panose="020B0604020202020204" pitchFamily="34" charset="0"/>
          <a:ea typeface="Arial Narrow" panose="020B0604020202020204" pitchFamily="34" charset="0"/>
          <a:cs typeface="Arial Narrow" panose="020B0604020202020204" pitchFamily="34" charset="0"/>
        </a:defRPr>
      </a:lvl9pPr>
    </p:titleStyle>
    <p:bodyStyle>
      <a:lvl1pPr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defRPr sz="1600" kern="1200">
          <a:solidFill>
            <a:schemeClr val="bg1"/>
          </a:solidFill>
          <a:latin typeface="Arial Narrow" charset="0"/>
          <a:ea typeface="Arial Narrow" charset="0"/>
          <a:cs typeface="Arial Narrow" charset="0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Arial Narrow" panose="020B0604020202020204" pitchFamily="34" charset="0"/>
          <a:cs typeface="Arial Narrow" panose="020B0604020202020204" pitchFamily="34" charset="0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Arial Narrow" panose="020B0604020202020204" pitchFamily="34" charset="0"/>
          <a:cs typeface="Arial Narrow" panose="020B0604020202020204" pitchFamily="34" charset="0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Arial Narrow" panose="020B0604020202020204" pitchFamily="34" charset="0"/>
          <a:cs typeface="Arial Narrow" panose="020B0604020202020204" pitchFamily="34" charset="0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Arial Narrow" panose="020B0604020202020204" pitchFamily="34" charset="0"/>
          <a:cs typeface="Arial Narrow" panose="020B0604020202020204" pitchFamily="34" charset="0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0B109A84-A783-4C41-A998-ACD175AB0E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95981"/>
            <a:ext cx="12192000" cy="2533019"/>
          </a:xfrm>
          <a:prstGeom prst="rect">
            <a:avLst/>
          </a:prstGeom>
        </p:spPr>
      </p:pic>
      <p:pic>
        <p:nvPicPr>
          <p:cNvPr id="7" name="Picture 6" descr="Graphical user interface, text, application&#10;&#10;Description automatically generated">
            <a:extLst>
              <a:ext uri="{FF2B5EF4-FFF2-40B4-BE49-F238E27FC236}">
                <a16:creationId xmlns:a16="http://schemas.microsoft.com/office/drawing/2014/main" id="{642E0FAD-7E33-0D4B-96E4-9540E50B12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339" y="3803542"/>
            <a:ext cx="12192000" cy="228355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23A6BD87-C3A0-494A-B253-DC19E0F3CD6B}"/>
              </a:ext>
            </a:extLst>
          </p:cNvPr>
          <p:cNvSpPr/>
          <p:nvPr/>
        </p:nvSpPr>
        <p:spPr>
          <a:xfrm>
            <a:off x="6607884" y="145092"/>
            <a:ext cx="3392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bstet</a:t>
            </a:r>
            <a:r>
              <a:rPr lang="en-AU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ynecol. 2003;101:921-8. </a:t>
            </a:r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79DFEFD-D3A9-5A4E-B4CD-D2F92352ED51}"/>
              </a:ext>
            </a:extLst>
          </p:cNvPr>
          <p:cNvSpPr/>
          <p:nvPr/>
        </p:nvSpPr>
        <p:spPr>
          <a:xfrm>
            <a:off x="152649" y="127697"/>
            <a:ext cx="41233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m J </a:t>
            </a:r>
            <a:r>
              <a:rPr lang="en-AU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bstet</a:t>
            </a:r>
            <a:r>
              <a:rPr lang="en-AU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ynecol. 2002;187:1038-45.</a:t>
            </a:r>
            <a:r>
              <a:rPr lang="en-AU" dirty="0">
                <a:effectLst/>
              </a:rPr>
              <a:t> </a:t>
            </a:r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5AFFCFB-8A61-3B4A-9936-1F0566D54168}"/>
              </a:ext>
            </a:extLst>
          </p:cNvPr>
          <p:cNvSpPr/>
          <p:nvPr/>
        </p:nvSpPr>
        <p:spPr>
          <a:xfrm>
            <a:off x="3826475" y="5375189"/>
            <a:ext cx="502508" cy="586830"/>
          </a:xfrm>
          <a:prstGeom prst="rect">
            <a:avLst/>
          </a:prstGeom>
          <a:solidFill>
            <a:srgbClr val="FFC000">
              <a:alpha val="33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32564591-4FDB-2F43-B8DC-919EA6F5C8EC}"/>
              </a:ext>
            </a:extLst>
          </p:cNvPr>
          <p:cNvSpPr/>
          <p:nvPr/>
        </p:nvSpPr>
        <p:spPr>
          <a:xfrm>
            <a:off x="10354961" y="5280453"/>
            <a:ext cx="502508" cy="681565"/>
          </a:xfrm>
          <a:prstGeom prst="rect">
            <a:avLst/>
          </a:prstGeom>
          <a:solidFill>
            <a:srgbClr val="FFC000">
              <a:alpha val="33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2F15FE9-2C27-5F46-B885-46CFF14CE922}"/>
              </a:ext>
            </a:extLst>
          </p:cNvPr>
          <p:cNvSpPr/>
          <p:nvPr/>
        </p:nvSpPr>
        <p:spPr>
          <a:xfrm>
            <a:off x="11343500" y="5311229"/>
            <a:ext cx="502508" cy="212241"/>
          </a:xfrm>
          <a:prstGeom prst="rect">
            <a:avLst/>
          </a:prstGeom>
          <a:solidFill>
            <a:srgbClr val="FFC000">
              <a:alpha val="33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0BF40EF-BF18-0D42-A9FA-732680B30A2F}"/>
              </a:ext>
            </a:extLst>
          </p:cNvPr>
          <p:cNvSpPr/>
          <p:nvPr/>
        </p:nvSpPr>
        <p:spPr>
          <a:xfrm>
            <a:off x="4815014" y="5359567"/>
            <a:ext cx="502508" cy="212241"/>
          </a:xfrm>
          <a:prstGeom prst="rect">
            <a:avLst/>
          </a:prstGeom>
          <a:solidFill>
            <a:srgbClr val="FFC000">
              <a:alpha val="33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05FD509-33CA-1444-8EE3-41754B00F76C}"/>
              </a:ext>
            </a:extLst>
          </p:cNvPr>
          <p:cNvSpPr/>
          <p:nvPr/>
        </p:nvSpPr>
        <p:spPr>
          <a:xfrm>
            <a:off x="4808974" y="4803732"/>
            <a:ext cx="445694" cy="131523"/>
          </a:xfrm>
          <a:prstGeom prst="rect">
            <a:avLst/>
          </a:prstGeom>
          <a:solidFill>
            <a:srgbClr val="FFC000">
              <a:alpha val="33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0B761F8-E3FA-4C49-BFBC-58A2C0314D4E}"/>
              </a:ext>
            </a:extLst>
          </p:cNvPr>
          <p:cNvSpPr/>
          <p:nvPr/>
        </p:nvSpPr>
        <p:spPr>
          <a:xfrm>
            <a:off x="11371907" y="4619666"/>
            <a:ext cx="445694" cy="131523"/>
          </a:xfrm>
          <a:prstGeom prst="rect">
            <a:avLst/>
          </a:prstGeom>
          <a:solidFill>
            <a:srgbClr val="FFC000">
              <a:alpha val="33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5674AB2-E281-664F-84C6-788BD059E2F7}"/>
              </a:ext>
            </a:extLst>
          </p:cNvPr>
          <p:cNvSpPr/>
          <p:nvPr/>
        </p:nvSpPr>
        <p:spPr>
          <a:xfrm>
            <a:off x="11400314" y="2024704"/>
            <a:ext cx="445694" cy="131523"/>
          </a:xfrm>
          <a:prstGeom prst="rect">
            <a:avLst/>
          </a:prstGeom>
          <a:solidFill>
            <a:srgbClr val="FFC000">
              <a:alpha val="33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6EED3F56-E0FE-074A-8AA4-7B4C9CAB55CB}"/>
              </a:ext>
            </a:extLst>
          </p:cNvPr>
          <p:cNvSpPr/>
          <p:nvPr/>
        </p:nvSpPr>
        <p:spPr>
          <a:xfrm>
            <a:off x="4843420" y="2023127"/>
            <a:ext cx="474101" cy="131523"/>
          </a:xfrm>
          <a:prstGeom prst="rect">
            <a:avLst/>
          </a:prstGeom>
          <a:solidFill>
            <a:srgbClr val="FFC000">
              <a:alpha val="33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C5ECCA39-11FB-CB44-A8DE-FDFB4A77550D}"/>
              </a:ext>
            </a:extLst>
          </p:cNvPr>
          <p:cNvSpPr/>
          <p:nvPr/>
        </p:nvSpPr>
        <p:spPr>
          <a:xfrm>
            <a:off x="3918581" y="2023127"/>
            <a:ext cx="196219" cy="131523"/>
          </a:xfrm>
          <a:prstGeom prst="rect">
            <a:avLst/>
          </a:prstGeom>
          <a:solidFill>
            <a:srgbClr val="FFC000">
              <a:alpha val="33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8AA642E-E15F-BD49-8468-2A908B143094}"/>
              </a:ext>
            </a:extLst>
          </p:cNvPr>
          <p:cNvSpPr/>
          <p:nvPr/>
        </p:nvSpPr>
        <p:spPr>
          <a:xfrm>
            <a:off x="10508105" y="2030967"/>
            <a:ext cx="196219" cy="131523"/>
          </a:xfrm>
          <a:prstGeom prst="rect">
            <a:avLst/>
          </a:prstGeom>
          <a:solidFill>
            <a:srgbClr val="FFC000">
              <a:alpha val="33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3189D958-1724-DB40-BC5A-2E9F62CC4A45}"/>
              </a:ext>
            </a:extLst>
          </p:cNvPr>
          <p:cNvSpPr/>
          <p:nvPr/>
        </p:nvSpPr>
        <p:spPr>
          <a:xfrm>
            <a:off x="11427740" y="5523470"/>
            <a:ext cx="167014" cy="533243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B0069F2B-BDB2-004A-ADD3-F811F37E7291}"/>
              </a:ext>
            </a:extLst>
          </p:cNvPr>
          <p:cNvSpPr/>
          <p:nvPr/>
        </p:nvSpPr>
        <p:spPr>
          <a:xfrm>
            <a:off x="4762989" y="5546006"/>
            <a:ext cx="167014" cy="533243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8386DA5-C5FD-D95F-9A2C-6F814DFDA920}"/>
              </a:ext>
            </a:extLst>
          </p:cNvPr>
          <p:cNvSpPr txBox="1"/>
          <p:nvPr/>
        </p:nvSpPr>
        <p:spPr>
          <a:xfrm>
            <a:off x="445419" y="6315087"/>
            <a:ext cx="92416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d squares and yellow fields indicate similar numbers in what are supposed to be different RCTs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14EE1A7-7CA8-0FD1-AC1B-91CB101A5318}"/>
              </a:ext>
            </a:extLst>
          </p:cNvPr>
          <p:cNvSpPr/>
          <p:nvPr/>
        </p:nvSpPr>
        <p:spPr>
          <a:xfrm>
            <a:off x="2016087" y="1795749"/>
            <a:ext cx="132202" cy="13220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46414EB-D79A-7666-D8D7-C78F3F9BCD0F}"/>
              </a:ext>
            </a:extLst>
          </p:cNvPr>
          <p:cNvSpPr/>
          <p:nvPr/>
        </p:nvSpPr>
        <p:spPr>
          <a:xfrm flipH="1">
            <a:off x="2105099" y="1917230"/>
            <a:ext cx="94763" cy="1137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E81B74F-A444-F3A2-D62E-4A7A20B2007B}"/>
              </a:ext>
            </a:extLst>
          </p:cNvPr>
          <p:cNvSpPr/>
          <p:nvPr/>
        </p:nvSpPr>
        <p:spPr>
          <a:xfrm flipH="1">
            <a:off x="3007422" y="1909390"/>
            <a:ext cx="132200" cy="1137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71688D82-A7B2-8349-3247-4D6186C87878}"/>
              </a:ext>
            </a:extLst>
          </p:cNvPr>
          <p:cNvSpPr/>
          <p:nvPr/>
        </p:nvSpPr>
        <p:spPr>
          <a:xfrm flipH="1">
            <a:off x="2030165" y="2559378"/>
            <a:ext cx="132200" cy="1137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67E07A7D-0837-D028-116B-033D143D5681}"/>
              </a:ext>
            </a:extLst>
          </p:cNvPr>
          <p:cNvSpPr/>
          <p:nvPr/>
        </p:nvSpPr>
        <p:spPr>
          <a:xfrm flipH="1">
            <a:off x="2585559" y="5014657"/>
            <a:ext cx="113467" cy="1137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FA6A986A-66D7-BB93-5139-CD8770A556A3}"/>
              </a:ext>
            </a:extLst>
          </p:cNvPr>
          <p:cNvSpPr/>
          <p:nvPr/>
        </p:nvSpPr>
        <p:spPr>
          <a:xfrm>
            <a:off x="8731898" y="1785027"/>
            <a:ext cx="132202" cy="13220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0A150EF2-C374-2B33-A9EC-06805D3C0D07}"/>
              </a:ext>
            </a:extLst>
          </p:cNvPr>
          <p:cNvSpPr/>
          <p:nvPr/>
        </p:nvSpPr>
        <p:spPr>
          <a:xfrm flipH="1">
            <a:off x="8813816" y="1930585"/>
            <a:ext cx="94763" cy="1137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9235702D-320A-C959-3214-4BE7AF3B599A}"/>
              </a:ext>
            </a:extLst>
          </p:cNvPr>
          <p:cNvSpPr/>
          <p:nvPr/>
        </p:nvSpPr>
        <p:spPr>
          <a:xfrm flipH="1">
            <a:off x="9634220" y="1906770"/>
            <a:ext cx="132200" cy="1137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9CAE5DF1-3793-9881-9481-4ED54F83F7C1}"/>
              </a:ext>
            </a:extLst>
          </p:cNvPr>
          <p:cNvSpPr/>
          <p:nvPr/>
        </p:nvSpPr>
        <p:spPr>
          <a:xfrm flipH="1">
            <a:off x="8723065" y="2584778"/>
            <a:ext cx="132200" cy="1137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D66EE5E9-1F77-F958-2886-821EFCAAFE5A}"/>
              </a:ext>
            </a:extLst>
          </p:cNvPr>
          <p:cNvSpPr/>
          <p:nvPr/>
        </p:nvSpPr>
        <p:spPr>
          <a:xfrm>
            <a:off x="11334764" y="2033612"/>
            <a:ext cx="92976" cy="2333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AEA84C2B-BF2A-88CD-A1EF-623031760BF0}"/>
              </a:ext>
            </a:extLst>
          </p:cNvPr>
          <p:cNvSpPr/>
          <p:nvPr/>
        </p:nvSpPr>
        <p:spPr>
          <a:xfrm>
            <a:off x="9006547" y="4818586"/>
            <a:ext cx="92976" cy="2333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2567072-B5C6-8F76-8D38-507F249CF637}"/>
              </a:ext>
            </a:extLst>
          </p:cNvPr>
          <p:cNvSpPr txBox="1"/>
          <p:nvPr/>
        </p:nvSpPr>
        <p:spPr>
          <a:xfrm>
            <a:off x="9884496" y="6461634"/>
            <a:ext cx="61146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With journal 31-03-22</a:t>
            </a:r>
            <a:r>
              <a:rPr lang="en-AU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9378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table of statistics with numbers and text&#10;&#10;Description automatically generated with medium confidence">
            <a:extLst>
              <a:ext uri="{FF2B5EF4-FFF2-40B4-BE49-F238E27FC236}">
                <a16:creationId xmlns:a16="http://schemas.microsoft.com/office/drawing/2014/main" id="{6EDDF1C6-2A03-A396-F252-C11E427793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90852" y="370772"/>
            <a:ext cx="4009201" cy="4275437"/>
          </a:xfrm>
          <a:prstGeom prst="rect">
            <a:avLst/>
          </a:prstGeom>
        </p:spPr>
      </p:pic>
      <p:pic>
        <p:nvPicPr>
          <p:cNvPr id="7" name="Picture 6" descr="A table with numbers and symbols&#10;&#10;Description automatically generated">
            <a:extLst>
              <a:ext uri="{FF2B5EF4-FFF2-40B4-BE49-F238E27FC236}">
                <a16:creationId xmlns:a16="http://schemas.microsoft.com/office/drawing/2014/main" id="{B016F5BD-8A4A-9ADC-0B17-92DFF8EEF9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647" y="272499"/>
            <a:ext cx="7772400" cy="558923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D364F23-B300-44D6-803C-14596AB5418E}"/>
              </a:ext>
            </a:extLst>
          </p:cNvPr>
          <p:cNvSpPr txBox="1"/>
          <p:nvPr/>
        </p:nvSpPr>
        <p:spPr>
          <a:xfrm>
            <a:off x="165055" y="43155"/>
            <a:ext cx="60980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AU" b="0" i="0" dirty="0">
                <a:effectLst/>
              </a:rPr>
              <a:t>Front Endocrinol 2020:11:129.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ECEB0A7-498C-4954-E371-3F70EED4A618}"/>
              </a:ext>
            </a:extLst>
          </p:cNvPr>
          <p:cNvSpPr/>
          <p:nvPr/>
        </p:nvSpPr>
        <p:spPr>
          <a:xfrm>
            <a:off x="2669894" y="1204057"/>
            <a:ext cx="864704" cy="218661"/>
          </a:xfrm>
          <a:prstGeom prst="rect">
            <a:avLst/>
          </a:prstGeom>
          <a:noFill/>
          <a:ln w="317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4B60C95-8CE3-4664-0C87-B6B589BE39E9}"/>
              </a:ext>
            </a:extLst>
          </p:cNvPr>
          <p:cNvSpPr/>
          <p:nvPr/>
        </p:nvSpPr>
        <p:spPr>
          <a:xfrm>
            <a:off x="9030748" y="1270218"/>
            <a:ext cx="864704" cy="218661"/>
          </a:xfrm>
          <a:prstGeom prst="rect">
            <a:avLst/>
          </a:prstGeom>
          <a:noFill/>
          <a:ln w="317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D433C11-0BD0-33A6-DC1B-84F45C4EBC5C}"/>
              </a:ext>
            </a:extLst>
          </p:cNvPr>
          <p:cNvSpPr/>
          <p:nvPr/>
        </p:nvSpPr>
        <p:spPr>
          <a:xfrm>
            <a:off x="9030748" y="1657396"/>
            <a:ext cx="864704" cy="218661"/>
          </a:xfrm>
          <a:prstGeom prst="rect">
            <a:avLst/>
          </a:prstGeom>
          <a:noFill/>
          <a:ln w="317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6264316-1E0A-2DF0-CA77-6F7CFCE5109E}"/>
              </a:ext>
            </a:extLst>
          </p:cNvPr>
          <p:cNvSpPr/>
          <p:nvPr/>
        </p:nvSpPr>
        <p:spPr>
          <a:xfrm>
            <a:off x="2669894" y="1601353"/>
            <a:ext cx="864704" cy="218661"/>
          </a:xfrm>
          <a:prstGeom prst="rect">
            <a:avLst/>
          </a:prstGeom>
          <a:noFill/>
          <a:ln w="317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879FC0C-C0A8-AB12-E0C0-5201FC7418E0}"/>
              </a:ext>
            </a:extLst>
          </p:cNvPr>
          <p:cNvSpPr/>
          <p:nvPr/>
        </p:nvSpPr>
        <p:spPr>
          <a:xfrm>
            <a:off x="9030748" y="2350896"/>
            <a:ext cx="864704" cy="218661"/>
          </a:xfrm>
          <a:prstGeom prst="rect">
            <a:avLst/>
          </a:prstGeom>
          <a:noFill/>
          <a:ln w="317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5CC854C-4159-ECFD-4F01-C09F62C39B08}"/>
              </a:ext>
            </a:extLst>
          </p:cNvPr>
          <p:cNvSpPr/>
          <p:nvPr/>
        </p:nvSpPr>
        <p:spPr>
          <a:xfrm>
            <a:off x="2669894" y="3961135"/>
            <a:ext cx="864704" cy="218661"/>
          </a:xfrm>
          <a:prstGeom prst="rect">
            <a:avLst/>
          </a:prstGeom>
          <a:noFill/>
          <a:ln w="317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6D7F03B-5819-D28B-EAB8-85A5FE7E2B8A}"/>
              </a:ext>
            </a:extLst>
          </p:cNvPr>
          <p:cNvSpPr/>
          <p:nvPr/>
        </p:nvSpPr>
        <p:spPr>
          <a:xfrm>
            <a:off x="2669894" y="4161301"/>
            <a:ext cx="864704" cy="218661"/>
          </a:xfrm>
          <a:prstGeom prst="rect">
            <a:avLst/>
          </a:prstGeom>
          <a:solidFill>
            <a:srgbClr val="FF0000">
              <a:alpha val="50586"/>
            </a:srgbClr>
          </a:solidFill>
          <a:ln w="317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5E98EC7A-D1CA-268B-86B8-01B306F04ABF}"/>
              </a:ext>
            </a:extLst>
          </p:cNvPr>
          <p:cNvSpPr/>
          <p:nvPr/>
        </p:nvSpPr>
        <p:spPr>
          <a:xfrm>
            <a:off x="9040085" y="3196170"/>
            <a:ext cx="864704" cy="218661"/>
          </a:xfrm>
          <a:prstGeom prst="rect">
            <a:avLst/>
          </a:prstGeom>
          <a:solidFill>
            <a:srgbClr val="FF0000">
              <a:alpha val="48000"/>
            </a:srgbClr>
          </a:solidFill>
          <a:ln w="317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D117B0E-D219-CEAF-6B82-AB5379021B6A}"/>
              </a:ext>
            </a:extLst>
          </p:cNvPr>
          <p:cNvSpPr/>
          <p:nvPr/>
        </p:nvSpPr>
        <p:spPr>
          <a:xfrm>
            <a:off x="9027035" y="3827887"/>
            <a:ext cx="371821" cy="213558"/>
          </a:xfrm>
          <a:prstGeom prst="rect">
            <a:avLst/>
          </a:prstGeom>
          <a:noFill/>
          <a:ln w="317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5BA9CC4F-9A8B-8041-6234-5B76870E5ED9}"/>
              </a:ext>
            </a:extLst>
          </p:cNvPr>
          <p:cNvSpPr/>
          <p:nvPr/>
        </p:nvSpPr>
        <p:spPr>
          <a:xfrm flipH="1">
            <a:off x="2643164" y="4758340"/>
            <a:ext cx="472558" cy="218662"/>
          </a:xfrm>
          <a:prstGeom prst="rect">
            <a:avLst/>
          </a:prstGeom>
          <a:noFill/>
          <a:ln w="317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C5124184-2DDA-A1AA-C257-EEB06E31CA97}"/>
              </a:ext>
            </a:extLst>
          </p:cNvPr>
          <p:cNvSpPr/>
          <p:nvPr/>
        </p:nvSpPr>
        <p:spPr>
          <a:xfrm>
            <a:off x="3433684" y="4764838"/>
            <a:ext cx="201827" cy="212164"/>
          </a:xfrm>
          <a:prstGeom prst="ellipse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002ECD44-C494-BCF6-FFC2-9CB5DD3457D7}"/>
              </a:ext>
            </a:extLst>
          </p:cNvPr>
          <p:cNvSpPr/>
          <p:nvPr/>
        </p:nvSpPr>
        <p:spPr>
          <a:xfrm>
            <a:off x="9736298" y="3844020"/>
            <a:ext cx="201827" cy="212164"/>
          </a:xfrm>
          <a:prstGeom prst="ellipse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46C3CC28-2E14-415F-8313-A1710BCD29EE}"/>
              </a:ext>
            </a:extLst>
          </p:cNvPr>
          <p:cNvSpPr/>
          <p:nvPr/>
        </p:nvSpPr>
        <p:spPr>
          <a:xfrm>
            <a:off x="8926121" y="1473015"/>
            <a:ext cx="200885" cy="213558"/>
          </a:xfrm>
          <a:prstGeom prst="ellipse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6199A2F7-26D1-4622-EB99-67D90FFC6FB1}"/>
              </a:ext>
            </a:extLst>
          </p:cNvPr>
          <p:cNvSpPr/>
          <p:nvPr/>
        </p:nvSpPr>
        <p:spPr>
          <a:xfrm>
            <a:off x="9786836" y="1466359"/>
            <a:ext cx="200885" cy="213558"/>
          </a:xfrm>
          <a:prstGeom prst="ellipse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881BB743-6FDD-2311-1FA8-B3630F1DA7B8}"/>
              </a:ext>
            </a:extLst>
          </p:cNvPr>
          <p:cNvSpPr/>
          <p:nvPr/>
        </p:nvSpPr>
        <p:spPr>
          <a:xfrm>
            <a:off x="3433684" y="1409326"/>
            <a:ext cx="200885" cy="213558"/>
          </a:xfrm>
          <a:prstGeom prst="ellipse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40ABEBEE-C94C-6DA0-65E7-A5FFDF791957}"/>
              </a:ext>
            </a:extLst>
          </p:cNvPr>
          <p:cNvSpPr/>
          <p:nvPr/>
        </p:nvSpPr>
        <p:spPr>
          <a:xfrm>
            <a:off x="2548150" y="1424215"/>
            <a:ext cx="200885" cy="213558"/>
          </a:xfrm>
          <a:prstGeom prst="ellipse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BE22BC6-6A76-D3BB-B909-D040CB6E4C20}"/>
              </a:ext>
            </a:extLst>
          </p:cNvPr>
          <p:cNvSpPr txBox="1"/>
          <p:nvPr/>
        </p:nvSpPr>
        <p:spPr>
          <a:xfrm>
            <a:off x="7468781" y="-43238"/>
            <a:ext cx="60980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dirty="0"/>
              <a:t>Guo et al. Reproductive Health 2022;19:198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F437452-7FFE-C91B-C7FC-FB018C8DC82C}"/>
              </a:ext>
            </a:extLst>
          </p:cNvPr>
          <p:cNvSpPr txBox="1"/>
          <p:nvPr/>
        </p:nvSpPr>
        <p:spPr>
          <a:xfrm>
            <a:off x="507657" y="6374798"/>
            <a:ext cx="9150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d squares and green dots indicate similar numbers in what are supposed to be different RCTs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CA27C46-280E-92F0-4D29-DB52BA544D5F}"/>
              </a:ext>
            </a:extLst>
          </p:cNvPr>
          <p:cNvSpPr txBox="1"/>
          <p:nvPr/>
        </p:nvSpPr>
        <p:spPr>
          <a:xfrm>
            <a:off x="7992539" y="5793130"/>
            <a:ext cx="6858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dirty="0"/>
              <a:t>March 2017 and September 2017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D92B622-20CF-7104-4D78-73C3D7116006}"/>
              </a:ext>
            </a:extLst>
          </p:cNvPr>
          <p:cNvSpPr txBox="1"/>
          <p:nvPr/>
        </p:nvSpPr>
        <p:spPr>
          <a:xfrm>
            <a:off x="311726" y="5847950"/>
            <a:ext cx="74474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AU" dirty="0"/>
              <a:t>May 2016 and March 2017.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5C3ED72-0FDA-F03A-3548-A305AAA5B4A0}"/>
              </a:ext>
            </a:extLst>
          </p:cNvPr>
          <p:cNvSpPr txBox="1"/>
          <p:nvPr/>
        </p:nvSpPr>
        <p:spPr>
          <a:xfrm>
            <a:off x="9884496" y="6461634"/>
            <a:ext cx="61146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With journal 04-04-24</a:t>
            </a:r>
            <a:r>
              <a:rPr lang="en-AU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72545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table with numbers and symbols&#10;&#10;Description automatically generated">
            <a:extLst>
              <a:ext uri="{FF2B5EF4-FFF2-40B4-BE49-F238E27FC236}">
                <a16:creationId xmlns:a16="http://schemas.microsoft.com/office/drawing/2014/main" id="{6262364A-DF93-DE71-4D69-0B7BFE71BF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55184" y="643774"/>
            <a:ext cx="6607386" cy="3690163"/>
          </a:xfrm>
          <a:prstGeom prst="rect">
            <a:avLst/>
          </a:prstGeom>
        </p:spPr>
      </p:pic>
      <p:pic>
        <p:nvPicPr>
          <p:cNvPr id="5" name="Picture 4" descr="A table of medical results&#10;&#10;Description automatically generated with medium confidence">
            <a:extLst>
              <a:ext uri="{FF2B5EF4-FFF2-40B4-BE49-F238E27FC236}">
                <a16:creationId xmlns:a16="http://schemas.microsoft.com/office/drawing/2014/main" id="{64BE2946-03A8-5D7B-16D3-DC4BF6FD7F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393" y="543758"/>
            <a:ext cx="5056980" cy="41045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DD4A961-11FE-BA7A-C08C-1ECEEDE0A8C8}"/>
              </a:ext>
            </a:extLst>
          </p:cNvPr>
          <p:cNvSpPr txBox="1"/>
          <p:nvPr/>
        </p:nvSpPr>
        <p:spPr>
          <a:xfrm>
            <a:off x="197847" y="4788070"/>
            <a:ext cx="1199341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AU" dirty="0">
              <a:latin typeface="Times New Roman" panose="02020603050405020304" pitchFamily="18" charset="0"/>
            </a:endParaRPr>
          </a:p>
          <a:p>
            <a:r>
              <a:rPr lang="en-AU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able 2 and 3 show almost only even numbers. The probability that this happens by chance is </a:t>
            </a:r>
            <a:r>
              <a:rPr lang="en-AU" b="0" i="0" dirty="0">
                <a:solidFill>
                  <a:srgbClr val="333333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0.00000000684 and 0.0007155, </a:t>
            </a:r>
          </a:p>
          <a:p>
            <a:r>
              <a:rPr lang="en-AU" b="0" i="0" dirty="0">
                <a:solidFill>
                  <a:srgbClr val="333333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respectively.</a:t>
            </a:r>
            <a:r>
              <a:rPr lang="en-AU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3779EB8-1E4D-8AEE-3814-E0B2FA2FBF53}"/>
              </a:ext>
            </a:extLst>
          </p:cNvPr>
          <p:cNvSpPr txBox="1"/>
          <p:nvPr/>
        </p:nvSpPr>
        <p:spPr>
          <a:xfrm>
            <a:off x="197847" y="44771"/>
            <a:ext cx="60978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ezk</a:t>
            </a:r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Pregnancy </a:t>
            </a:r>
            <a:r>
              <a:rPr lang="en-AU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ypertens</a:t>
            </a:r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2016; 6: 291-294</a:t>
            </a:r>
            <a:r>
              <a:rPr lang="en-AU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CBA3448-1AA3-4EB5-7562-221192073FBA}"/>
              </a:ext>
            </a:extLst>
          </p:cNvPr>
          <p:cNvSpPr txBox="1"/>
          <p:nvPr/>
        </p:nvSpPr>
        <p:spPr>
          <a:xfrm>
            <a:off x="9884496" y="6461634"/>
            <a:ext cx="61146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With journal 07-11-21</a:t>
            </a:r>
            <a:r>
              <a:rPr lang="en-AU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70173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medical report&#10;&#10;Description automatically generated">
            <a:extLst>
              <a:ext uri="{FF2B5EF4-FFF2-40B4-BE49-F238E27FC236}">
                <a16:creationId xmlns:a16="http://schemas.microsoft.com/office/drawing/2014/main" id="{FCF646C4-ED99-A647-1031-B3F423F57A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17066" y="2689390"/>
            <a:ext cx="5349344" cy="2666270"/>
          </a:xfrm>
          <a:prstGeom prst="rect">
            <a:avLst/>
          </a:prstGeom>
        </p:spPr>
      </p:pic>
      <p:pic>
        <p:nvPicPr>
          <p:cNvPr id="7" name="Picture 6" descr="A table with numbers and text&#10;&#10;Description automatically generated">
            <a:extLst>
              <a:ext uri="{FF2B5EF4-FFF2-40B4-BE49-F238E27FC236}">
                <a16:creationId xmlns:a16="http://schemas.microsoft.com/office/drawing/2014/main" id="{4910F9EE-50A4-49E4-DA20-1C0BABB2DB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504" y="2689390"/>
            <a:ext cx="6780566" cy="2359381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88E511DB-7B41-3072-A756-5C61BE3EB7F9}"/>
              </a:ext>
            </a:extLst>
          </p:cNvPr>
          <p:cNvSpPr/>
          <p:nvPr/>
        </p:nvSpPr>
        <p:spPr>
          <a:xfrm>
            <a:off x="9804680" y="3580981"/>
            <a:ext cx="611006" cy="245053"/>
          </a:xfrm>
          <a:prstGeom prst="rect">
            <a:avLst/>
          </a:prstGeom>
          <a:solidFill>
            <a:srgbClr val="FF0000">
              <a:alpha val="12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7B81E81-157E-E1C9-AE74-8A81FBB92D7F}"/>
              </a:ext>
            </a:extLst>
          </p:cNvPr>
          <p:cNvSpPr/>
          <p:nvPr/>
        </p:nvSpPr>
        <p:spPr>
          <a:xfrm>
            <a:off x="5292090" y="3510115"/>
            <a:ext cx="611006" cy="315919"/>
          </a:xfrm>
          <a:prstGeom prst="rect">
            <a:avLst/>
          </a:prstGeom>
          <a:solidFill>
            <a:srgbClr val="FF0000">
              <a:alpha val="12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D965CE7-B9E2-8643-E289-EB9D2B28874B}"/>
              </a:ext>
            </a:extLst>
          </p:cNvPr>
          <p:cNvSpPr/>
          <p:nvPr/>
        </p:nvSpPr>
        <p:spPr>
          <a:xfrm>
            <a:off x="4029123" y="3510115"/>
            <a:ext cx="543701" cy="315919"/>
          </a:xfrm>
          <a:prstGeom prst="rect">
            <a:avLst/>
          </a:prstGeom>
          <a:solidFill>
            <a:schemeClr val="accent6">
              <a:alpha val="12000"/>
            </a:schemeClr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6A31211-C70B-9A7A-F078-00FCEA2974A2}"/>
              </a:ext>
            </a:extLst>
          </p:cNvPr>
          <p:cNvSpPr/>
          <p:nvPr/>
        </p:nvSpPr>
        <p:spPr>
          <a:xfrm>
            <a:off x="8960876" y="3580981"/>
            <a:ext cx="543701" cy="245053"/>
          </a:xfrm>
          <a:prstGeom prst="rect">
            <a:avLst/>
          </a:prstGeom>
          <a:solidFill>
            <a:schemeClr val="accent6">
              <a:alpha val="12000"/>
            </a:schemeClr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7727802-223C-D40C-73EB-6FAF9579F9F5}"/>
              </a:ext>
            </a:extLst>
          </p:cNvPr>
          <p:cNvSpPr/>
          <p:nvPr/>
        </p:nvSpPr>
        <p:spPr>
          <a:xfrm>
            <a:off x="9864090" y="4518629"/>
            <a:ext cx="611006" cy="118483"/>
          </a:xfrm>
          <a:prstGeom prst="rect">
            <a:avLst/>
          </a:prstGeom>
          <a:solidFill>
            <a:srgbClr val="FF0000">
              <a:alpha val="12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778805C3-504F-4AE8-92E5-652BBA60C7D5}"/>
              </a:ext>
            </a:extLst>
          </p:cNvPr>
          <p:cNvSpPr/>
          <p:nvPr/>
        </p:nvSpPr>
        <p:spPr>
          <a:xfrm>
            <a:off x="8919328" y="4521550"/>
            <a:ext cx="611006" cy="118483"/>
          </a:xfrm>
          <a:prstGeom prst="rect">
            <a:avLst/>
          </a:prstGeom>
          <a:solidFill>
            <a:srgbClr val="FF0000">
              <a:alpha val="12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A644332-0DA5-8BC9-867B-A119A6597260}"/>
              </a:ext>
            </a:extLst>
          </p:cNvPr>
          <p:cNvSpPr/>
          <p:nvPr/>
        </p:nvSpPr>
        <p:spPr>
          <a:xfrm>
            <a:off x="4029123" y="4683925"/>
            <a:ext cx="598092" cy="118483"/>
          </a:xfrm>
          <a:prstGeom prst="rect">
            <a:avLst/>
          </a:prstGeom>
          <a:solidFill>
            <a:schemeClr val="accent6">
              <a:alpha val="12000"/>
            </a:schemeClr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88F3CE3-A88B-373C-B06F-362153108CCE}"/>
              </a:ext>
            </a:extLst>
          </p:cNvPr>
          <p:cNvSpPr/>
          <p:nvPr/>
        </p:nvSpPr>
        <p:spPr>
          <a:xfrm>
            <a:off x="5306441" y="4543314"/>
            <a:ext cx="611006" cy="118483"/>
          </a:xfrm>
          <a:prstGeom prst="rect">
            <a:avLst/>
          </a:prstGeom>
          <a:solidFill>
            <a:srgbClr val="FF0000">
              <a:alpha val="12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153083F-5BB1-0734-BCE3-692D107C6D97}"/>
              </a:ext>
            </a:extLst>
          </p:cNvPr>
          <p:cNvSpPr/>
          <p:nvPr/>
        </p:nvSpPr>
        <p:spPr>
          <a:xfrm>
            <a:off x="4016209" y="4538552"/>
            <a:ext cx="611006" cy="118483"/>
          </a:xfrm>
          <a:prstGeom prst="rect">
            <a:avLst/>
          </a:prstGeom>
          <a:solidFill>
            <a:srgbClr val="FF0000">
              <a:alpha val="12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E2F3244-76C4-A678-6673-F549B54A8E7F}"/>
              </a:ext>
            </a:extLst>
          </p:cNvPr>
          <p:cNvSpPr/>
          <p:nvPr/>
        </p:nvSpPr>
        <p:spPr>
          <a:xfrm>
            <a:off x="8993646" y="4746067"/>
            <a:ext cx="598092" cy="118483"/>
          </a:xfrm>
          <a:prstGeom prst="rect">
            <a:avLst/>
          </a:prstGeom>
          <a:solidFill>
            <a:schemeClr val="accent6">
              <a:alpha val="12000"/>
            </a:schemeClr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3B8E93DA-4D28-AF60-C238-2FB3F8021F3A}"/>
              </a:ext>
            </a:extLst>
          </p:cNvPr>
          <p:cNvSpPr/>
          <p:nvPr/>
        </p:nvSpPr>
        <p:spPr>
          <a:xfrm>
            <a:off x="9260880" y="4406371"/>
            <a:ext cx="269454" cy="132181"/>
          </a:xfrm>
          <a:prstGeom prst="rect">
            <a:avLst/>
          </a:prstGeom>
          <a:solidFill>
            <a:srgbClr val="FF0000">
              <a:alpha val="12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4A19AE0F-4558-D7E8-261D-3CA0A15F8571}"/>
              </a:ext>
            </a:extLst>
          </p:cNvPr>
          <p:cNvSpPr/>
          <p:nvPr/>
        </p:nvSpPr>
        <p:spPr>
          <a:xfrm>
            <a:off x="10174646" y="4388965"/>
            <a:ext cx="269454" cy="132181"/>
          </a:xfrm>
          <a:prstGeom prst="rect">
            <a:avLst/>
          </a:prstGeom>
          <a:solidFill>
            <a:srgbClr val="FF0000">
              <a:alpha val="12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A5FD7DB-425C-22B9-22E6-C9A3DBB3F638}"/>
              </a:ext>
            </a:extLst>
          </p:cNvPr>
          <p:cNvSpPr txBox="1"/>
          <p:nvPr/>
        </p:nvSpPr>
        <p:spPr>
          <a:xfrm>
            <a:off x="284713" y="147517"/>
            <a:ext cx="488370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J Assist </a:t>
            </a:r>
            <a:r>
              <a:rPr lang="en-US" dirty="0" err="1"/>
              <a:t>Reprod</a:t>
            </a:r>
            <a:r>
              <a:rPr lang="en-US" dirty="0"/>
              <a:t> Genet 2007;24:400-5.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5E4A4CB-E489-508B-5086-88AC917F8D0D}"/>
              </a:ext>
            </a:extLst>
          </p:cNvPr>
          <p:cNvSpPr txBox="1"/>
          <p:nvPr/>
        </p:nvSpPr>
        <p:spPr>
          <a:xfrm>
            <a:off x="6938285" y="186418"/>
            <a:ext cx="61218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Fertil</a:t>
            </a:r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en-AU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teril</a:t>
            </a:r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2010;94:1782-6. 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426C4C8-49E5-0F8C-347E-35E5E4BF915A}"/>
              </a:ext>
            </a:extLst>
          </p:cNvPr>
          <p:cNvSpPr txBox="1"/>
          <p:nvPr/>
        </p:nvSpPr>
        <p:spPr>
          <a:xfrm>
            <a:off x="425358" y="5816514"/>
            <a:ext cx="65092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80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Recruitment  </a:t>
            </a:r>
            <a:r>
              <a:rPr lang="en-AU" sz="1800" dirty="0">
                <a:solidFill>
                  <a:srgbClr val="11111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June 2005 to March 2006. </a:t>
            </a:r>
            <a:endParaRPr lang="en-AU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7" name="Picture 26" descr="A black text on a white background&#10;&#10;Description automatically generated">
            <a:extLst>
              <a:ext uri="{FF2B5EF4-FFF2-40B4-BE49-F238E27FC236}">
                <a16:creationId xmlns:a16="http://schemas.microsoft.com/office/drawing/2014/main" id="{DC569DC4-252A-C23E-BA0C-49F1E9A5E4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43973" y="903275"/>
            <a:ext cx="4761715" cy="1241404"/>
          </a:xfrm>
          <a:prstGeom prst="rect">
            <a:avLst/>
          </a:prstGeom>
        </p:spPr>
      </p:pic>
      <p:pic>
        <p:nvPicPr>
          <p:cNvPr id="29" name="Picture 28" descr="A close-up of a medical information&#10;&#10;Description automatically generated">
            <a:extLst>
              <a:ext uri="{FF2B5EF4-FFF2-40B4-BE49-F238E27FC236}">
                <a16:creationId xmlns:a16="http://schemas.microsoft.com/office/drawing/2014/main" id="{EA6ABD38-691C-1153-1449-AF9A0D7950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2809" y="672154"/>
            <a:ext cx="4858066" cy="1883011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6ADB00E5-A965-B616-F0D9-D4D56645242B}"/>
              </a:ext>
            </a:extLst>
          </p:cNvPr>
          <p:cNvSpPr txBox="1"/>
          <p:nvPr/>
        </p:nvSpPr>
        <p:spPr>
          <a:xfrm>
            <a:off x="5648534" y="5715705"/>
            <a:ext cx="65887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80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Recruitment  January 2008 to February 2009 </a:t>
            </a:r>
            <a:endParaRPr lang="en-AU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449582DB-184D-D8D7-09EC-27A5B443C3BC}"/>
              </a:ext>
            </a:extLst>
          </p:cNvPr>
          <p:cNvSpPr/>
          <p:nvPr/>
        </p:nvSpPr>
        <p:spPr>
          <a:xfrm>
            <a:off x="8014123" y="6247875"/>
            <a:ext cx="1602081" cy="315919"/>
          </a:xfrm>
          <a:prstGeom prst="rect">
            <a:avLst/>
          </a:prstGeom>
          <a:solidFill>
            <a:srgbClr val="FF0000">
              <a:alpha val="12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rgbClr val="FF0000"/>
                </a:solidFill>
              </a:rPr>
              <a:t>Identical number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30FBDACE-D046-712C-D63F-EBCC9EDDC7C9}"/>
              </a:ext>
            </a:extLst>
          </p:cNvPr>
          <p:cNvSpPr/>
          <p:nvPr/>
        </p:nvSpPr>
        <p:spPr>
          <a:xfrm>
            <a:off x="9763932" y="6249933"/>
            <a:ext cx="1751309" cy="315919"/>
          </a:xfrm>
          <a:prstGeom prst="rect">
            <a:avLst/>
          </a:prstGeom>
          <a:solidFill>
            <a:schemeClr val="accent6">
              <a:alpha val="12000"/>
            </a:schemeClr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rgbClr val="00B050"/>
                </a:solidFill>
              </a:rPr>
              <a:t>1-2 digits difference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8411B51-5FA2-673E-6388-9ECE9E6CF698}"/>
              </a:ext>
            </a:extLst>
          </p:cNvPr>
          <p:cNvSpPr/>
          <p:nvPr/>
        </p:nvSpPr>
        <p:spPr>
          <a:xfrm flipV="1">
            <a:off x="5600801" y="4389831"/>
            <a:ext cx="269454" cy="118483"/>
          </a:xfrm>
          <a:prstGeom prst="rect">
            <a:avLst/>
          </a:prstGeom>
          <a:solidFill>
            <a:srgbClr val="FF0000">
              <a:alpha val="12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A1447E-5C1D-971A-BFD4-B1DA9721E5F7}"/>
              </a:ext>
            </a:extLst>
          </p:cNvPr>
          <p:cNvSpPr txBox="1"/>
          <p:nvPr/>
        </p:nvSpPr>
        <p:spPr>
          <a:xfrm>
            <a:off x="9864090" y="6514178"/>
            <a:ext cx="61146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With journal 04-01-24</a:t>
            </a:r>
            <a:r>
              <a:rPr lang="en-AU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73920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F40F7BDF-9854-6043-986B-837F25BB5438}"/>
              </a:ext>
            </a:extLst>
          </p:cNvPr>
          <p:cNvGrpSpPr/>
          <p:nvPr/>
        </p:nvGrpSpPr>
        <p:grpSpPr>
          <a:xfrm>
            <a:off x="182778" y="186568"/>
            <a:ext cx="11454625" cy="6049120"/>
            <a:chOff x="253899" y="320149"/>
            <a:chExt cx="9324812" cy="4517995"/>
          </a:xfrm>
        </p:grpSpPr>
        <p:pic>
          <p:nvPicPr>
            <p:cNvPr id="49" name="Picture 48" descr="Table&#10;&#10;Description automatically generated">
              <a:extLst>
                <a:ext uri="{FF2B5EF4-FFF2-40B4-BE49-F238E27FC236}">
                  <a16:creationId xmlns:a16="http://schemas.microsoft.com/office/drawing/2014/main" id="{143C2173-5513-A94E-AF13-1BCE54C9803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3899" y="320149"/>
              <a:ext cx="9324812" cy="4517995"/>
            </a:xfrm>
            <a:prstGeom prst="rect">
              <a:avLst/>
            </a:prstGeom>
          </p:spPr>
        </p:pic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46380213-741D-7845-BE8C-CD0B3865D3A3}"/>
                </a:ext>
              </a:extLst>
            </p:cNvPr>
            <p:cNvSpPr/>
            <p:nvPr/>
          </p:nvSpPr>
          <p:spPr>
            <a:xfrm>
              <a:off x="2983041" y="3258437"/>
              <a:ext cx="616322" cy="389208"/>
            </a:xfrm>
            <a:prstGeom prst="rect">
              <a:avLst/>
            </a:prstGeom>
            <a:solidFill>
              <a:srgbClr val="FF0000">
                <a:alpha val="9804"/>
              </a:srgb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65B3AE59-0CA1-4B4E-A9E8-273605DFE0E3}"/>
                </a:ext>
              </a:extLst>
            </p:cNvPr>
            <p:cNvSpPr/>
            <p:nvPr/>
          </p:nvSpPr>
          <p:spPr>
            <a:xfrm>
              <a:off x="3044570" y="1775921"/>
              <a:ext cx="528947" cy="389209"/>
            </a:xfrm>
            <a:prstGeom prst="rect">
              <a:avLst/>
            </a:prstGeom>
            <a:solidFill>
              <a:srgbClr val="FF0000">
                <a:alpha val="9804"/>
              </a:srgb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C5F484F1-DFB2-6941-94BB-6EDF0D505A1E}"/>
                </a:ext>
              </a:extLst>
            </p:cNvPr>
            <p:cNvSpPr/>
            <p:nvPr/>
          </p:nvSpPr>
          <p:spPr>
            <a:xfrm>
              <a:off x="4741990" y="1775921"/>
              <a:ext cx="528947" cy="389209"/>
            </a:xfrm>
            <a:prstGeom prst="rect">
              <a:avLst/>
            </a:prstGeom>
            <a:solidFill>
              <a:srgbClr val="FF0000">
                <a:alpha val="9804"/>
              </a:srgb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169399AD-E2E0-E546-9DA5-E296C4C51819}"/>
                </a:ext>
              </a:extLst>
            </p:cNvPr>
            <p:cNvSpPr/>
            <p:nvPr/>
          </p:nvSpPr>
          <p:spPr>
            <a:xfrm>
              <a:off x="3070415" y="2312276"/>
              <a:ext cx="528947" cy="576421"/>
            </a:xfrm>
            <a:prstGeom prst="rect">
              <a:avLst/>
            </a:prstGeom>
            <a:solidFill>
              <a:srgbClr val="FF0000">
                <a:alpha val="9804"/>
              </a:srgb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25009EA0-EB5E-7042-92E0-B27A1B31C629}"/>
                </a:ext>
              </a:extLst>
            </p:cNvPr>
            <p:cNvSpPr/>
            <p:nvPr/>
          </p:nvSpPr>
          <p:spPr>
            <a:xfrm>
              <a:off x="4725793" y="2323650"/>
              <a:ext cx="528947" cy="576421"/>
            </a:xfrm>
            <a:prstGeom prst="rect">
              <a:avLst/>
            </a:prstGeom>
            <a:solidFill>
              <a:srgbClr val="FF0000">
                <a:alpha val="9804"/>
              </a:srgb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29662EFC-D4E1-4049-B677-3C44BA312B0A}"/>
                </a:ext>
              </a:extLst>
            </p:cNvPr>
            <p:cNvSpPr/>
            <p:nvPr/>
          </p:nvSpPr>
          <p:spPr>
            <a:xfrm>
              <a:off x="4942111" y="3244073"/>
              <a:ext cx="807613" cy="389210"/>
            </a:xfrm>
            <a:prstGeom prst="rect">
              <a:avLst/>
            </a:prstGeom>
            <a:solidFill>
              <a:srgbClr val="FF0000">
                <a:alpha val="9804"/>
              </a:srgb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CE60580E-836B-0C66-6BAA-944D592BE5A0}"/>
              </a:ext>
            </a:extLst>
          </p:cNvPr>
          <p:cNvSpPr txBox="1"/>
          <p:nvPr/>
        </p:nvSpPr>
        <p:spPr>
          <a:xfrm>
            <a:off x="392628" y="31183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ea typeface="Times New Roman" panose="02020603050405020304" pitchFamily="18" charset="0"/>
              </a:rPr>
              <a:t>Int J Gyn </a:t>
            </a:r>
            <a:r>
              <a:rPr lang="en-US" sz="1800" dirty="0" err="1">
                <a:effectLst/>
                <a:ea typeface="Times New Roman" panose="02020603050405020304" pitchFamily="18" charset="0"/>
              </a:rPr>
              <a:t>Obstet</a:t>
            </a:r>
            <a:r>
              <a:rPr lang="en-US" sz="1800" dirty="0">
                <a:effectLst/>
                <a:ea typeface="Times New Roman" panose="02020603050405020304" pitchFamily="18" charset="0"/>
              </a:rPr>
              <a:t> 2005;89:7-13.</a:t>
            </a:r>
            <a:r>
              <a:rPr lang="en-AU" dirty="0">
                <a:effectLst/>
              </a:rPr>
              <a:t> </a:t>
            </a:r>
            <a:endParaRPr lang="en-US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36E198C0-B306-CE06-1638-74C8FFD1CB94}"/>
              </a:ext>
            </a:extLst>
          </p:cNvPr>
          <p:cNvSpPr/>
          <p:nvPr/>
        </p:nvSpPr>
        <p:spPr>
          <a:xfrm>
            <a:off x="392628" y="5944870"/>
            <a:ext cx="8555136" cy="403947"/>
          </a:xfrm>
          <a:prstGeom prst="rect">
            <a:avLst/>
          </a:prstGeom>
          <a:solidFill>
            <a:srgbClr val="FF0000">
              <a:alpha val="9804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Red squares indicate evident data-fabrication by generation of data from identical digits.</a:t>
            </a:r>
            <a:r>
              <a:rPr lang="en-US" dirty="0"/>
              <a:t> </a:t>
            </a:r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AB44DBE9-8D57-FFE2-DF4D-5831DFE02C5E}"/>
              </a:ext>
            </a:extLst>
          </p:cNvPr>
          <p:cNvSpPr/>
          <p:nvPr/>
        </p:nvSpPr>
        <p:spPr>
          <a:xfrm>
            <a:off x="7596990" y="1175389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38040E9D-20A4-C673-F13A-55165A3CD322}"/>
              </a:ext>
            </a:extLst>
          </p:cNvPr>
          <p:cNvSpPr/>
          <p:nvPr/>
        </p:nvSpPr>
        <p:spPr>
          <a:xfrm>
            <a:off x="7588026" y="1690858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BAE53A34-40F0-1658-06A8-558930E04D9C}"/>
              </a:ext>
            </a:extLst>
          </p:cNvPr>
          <p:cNvSpPr/>
          <p:nvPr/>
        </p:nvSpPr>
        <p:spPr>
          <a:xfrm>
            <a:off x="7592509" y="1923940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769DF334-8894-4133-9B1E-4CB0E45C9F09}"/>
              </a:ext>
            </a:extLst>
          </p:cNvPr>
          <p:cNvSpPr/>
          <p:nvPr/>
        </p:nvSpPr>
        <p:spPr>
          <a:xfrm>
            <a:off x="7601473" y="2174950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93E17C30-775E-9CBD-B569-924243D8BAB0}"/>
              </a:ext>
            </a:extLst>
          </p:cNvPr>
          <p:cNvSpPr/>
          <p:nvPr/>
        </p:nvSpPr>
        <p:spPr>
          <a:xfrm>
            <a:off x="7605956" y="2448373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8BE18E6F-1861-0913-4062-AF67A7574AED}"/>
              </a:ext>
            </a:extLst>
          </p:cNvPr>
          <p:cNvSpPr/>
          <p:nvPr/>
        </p:nvSpPr>
        <p:spPr>
          <a:xfrm>
            <a:off x="7596992" y="2708349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19D9CE4B-288A-7145-DEC9-962047A883EE}"/>
              </a:ext>
            </a:extLst>
          </p:cNvPr>
          <p:cNvSpPr/>
          <p:nvPr/>
        </p:nvSpPr>
        <p:spPr>
          <a:xfrm>
            <a:off x="7588026" y="2954879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395C5E20-A1F4-08C1-7AB5-2AEE70562049}"/>
              </a:ext>
            </a:extLst>
          </p:cNvPr>
          <p:cNvSpPr/>
          <p:nvPr/>
        </p:nvSpPr>
        <p:spPr>
          <a:xfrm>
            <a:off x="7579062" y="3187961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4B2263E3-5BE9-AAC1-55CA-21B2ECE60580}"/>
              </a:ext>
            </a:extLst>
          </p:cNvPr>
          <p:cNvSpPr/>
          <p:nvPr/>
        </p:nvSpPr>
        <p:spPr>
          <a:xfrm>
            <a:off x="7583545" y="3421043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98F3C447-F75F-7664-D987-6469B8B24F32}"/>
              </a:ext>
            </a:extLst>
          </p:cNvPr>
          <p:cNvSpPr/>
          <p:nvPr/>
        </p:nvSpPr>
        <p:spPr>
          <a:xfrm>
            <a:off x="7552168" y="3954440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D9003678-C4EC-10B5-E074-F394184948AD}"/>
              </a:ext>
            </a:extLst>
          </p:cNvPr>
          <p:cNvSpPr/>
          <p:nvPr/>
        </p:nvSpPr>
        <p:spPr>
          <a:xfrm>
            <a:off x="7543204" y="4187522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F02D2534-58F0-6B56-127F-3B48E86E90FC}"/>
              </a:ext>
            </a:extLst>
          </p:cNvPr>
          <p:cNvSpPr/>
          <p:nvPr/>
        </p:nvSpPr>
        <p:spPr>
          <a:xfrm>
            <a:off x="7547687" y="4420604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C063CEAF-9C75-4AF3-4E02-3A082A92B841}"/>
              </a:ext>
            </a:extLst>
          </p:cNvPr>
          <p:cNvSpPr/>
          <p:nvPr/>
        </p:nvSpPr>
        <p:spPr>
          <a:xfrm>
            <a:off x="7520793" y="4689544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5B4DA327-5940-CFA7-DC6D-C05D25763850}"/>
              </a:ext>
            </a:extLst>
          </p:cNvPr>
          <p:cNvSpPr/>
          <p:nvPr/>
        </p:nvSpPr>
        <p:spPr>
          <a:xfrm>
            <a:off x="7525276" y="4922626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510C038A-A8A7-679E-8DA9-2CF143A707C5}"/>
              </a:ext>
            </a:extLst>
          </p:cNvPr>
          <p:cNvSpPr/>
          <p:nvPr/>
        </p:nvSpPr>
        <p:spPr>
          <a:xfrm>
            <a:off x="564172" y="6460067"/>
            <a:ext cx="162560" cy="184558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accent6"/>
              </a:solidFill>
              <a:highlight>
                <a:srgbClr val="FF0000"/>
              </a:highlight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EE3384B-239D-5D29-C53D-61A785BB3C21}"/>
              </a:ext>
            </a:extLst>
          </p:cNvPr>
          <p:cNvSpPr txBox="1"/>
          <p:nvPr/>
        </p:nvSpPr>
        <p:spPr>
          <a:xfrm>
            <a:off x="-1110945" y="6391073"/>
            <a:ext cx="950707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Red circles indicate wrong calculations of the absolute rise.</a:t>
            </a:r>
            <a:r>
              <a:rPr lang="en-US" dirty="0"/>
              <a:t>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859564A-401F-43B2-897F-0E6CF34E95DD}"/>
              </a:ext>
            </a:extLst>
          </p:cNvPr>
          <p:cNvSpPr txBox="1"/>
          <p:nvPr/>
        </p:nvSpPr>
        <p:spPr>
          <a:xfrm>
            <a:off x="9884496" y="6461634"/>
            <a:ext cx="61146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With journal 03-04-21</a:t>
            </a:r>
            <a:r>
              <a:rPr lang="en-AU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30163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table with numbers and a green and yellow background&#10;&#10;Description automatically generated">
            <a:extLst>
              <a:ext uri="{FF2B5EF4-FFF2-40B4-BE49-F238E27FC236}">
                <a16:creationId xmlns:a16="http://schemas.microsoft.com/office/drawing/2014/main" id="{59805716-C1D3-DD6E-FE15-FC8B0FA43F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650" y="1106169"/>
            <a:ext cx="11303374" cy="295777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0DDECE5-D940-4129-E974-808F25F00971}"/>
              </a:ext>
            </a:extLst>
          </p:cNvPr>
          <p:cNvSpPr txBox="1"/>
          <p:nvPr/>
        </p:nvSpPr>
        <p:spPr>
          <a:xfrm>
            <a:off x="247650" y="304817"/>
            <a:ext cx="609824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AU" b="0" i="0" dirty="0">
                <a:effectLst/>
                <a:latin typeface="system-ui"/>
              </a:rPr>
              <a:t>BMC Pregnancy Childbirth. 2022 Aug 18;22(1):650.</a:t>
            </a:r>
          </a:p>
          <a:p>
            <a:r>
              <a:rPr lang="en-AU" b="0" i="0" dirty="0">
                <a:effectLst/>
                <a:latin typeface="system-ui"/>
              </a:rPr>
              <a:t> 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274F37F-DB81-412E-2D42-E2952DA8F604}"/>
              </a:ext>
            </a:extLst>
          </p:cNvPr>
          <p:cNvSpPr txBox="1"/>
          <p:nvPr/>
        </p:nvSpPr>
        <p:spPr>
          <a:xfrm>
            <a:off x="247650" y="4399280"/>
            <a:ext cx="1186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sorting of the dataset published online shows that the 60 patients in the control group are made up of 30 identical pairs. 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43D51D9-D030-54BA-EA65-7D352E329946}"/>
              </a:ext>
            </a:extLst>
          </p:cNvPr>
          <p:cNvSpPr txBox="1"/>
          <p:nvPr/>
        </p:nvSpPr>
        <p:spPr>
          <a:xfrm>
            <a:off x="9884496" y="6461634"/>
            <a:ext cx="61146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With journal 08-04-24</a:t>
            </a:r>
            <a:r>
              <a:rPr lang="en-AU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792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Image Deck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03</TotalTime>
  <Words>208</Words>
  <Application>Microsoft Macintosh PowerPoint</Application>
  <PresentationFormat>Widescreen</PresentationFormat>
  <Paragraphs>3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Calibri Light</vt:lpstr>
      <vt:lpstr>system-ui</vt:lpstr>
      <vt:lpstr>Times New Roman</vt:lpstr>
      <vt:lpstr>Office Theme</vt:lpstr>
      <vt:lpstr>1_Image Deck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 Mol</dc:creator>
  <cp:lastModifiedBy>Ben Mol</cp:lastModifiedBy>
  <cp:revision>94</cp:revision>
  <dcterms:created xsi:type="dcterms:W3CDTF">2020-11-26T00:50:34Z</dcterms:created>
  <dcterms:modified xsi:type="dcterms:W3CDTF">2024-12-19T22:42:12Z</dcterms:modified>
</cp:coreProperties>
</file>